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0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6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52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noSoilPhos\Lys_P-adsorption_isotherm\Lys_P-adsorption_isotherms_KB_without_blank_subtracte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noSoilPhos\Lys_P-adsorption_isotherm\Lys_P-adsorption_isotherms_KB_without_blank_subtracted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noSoilPhos\Lys_P-adsorption_isotherm\Lys_P-adsorption_isotherms_KB_without_blank_subtracte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noSoilPhos\Lys_P-adsorption_isotherm\Lys_P-adsorption_isotherms_KB_without_blank_subtracted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noSoilPhos\Lys_P-adsorption_isotherm\Lys_P-adsorption_isotherms_KB_without_blank_subtracted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noSoilPhos\Lys_P-adsorption_isotherm\Lys_P-adsorption_isotherms_KB_without_blank_subtracted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noSoilPhos\Lys_P-adsorption_isotherm\Lys_P-adsorption_isotherms_KB_without_blank_subtracted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noSoilPhos\Lys_P-adsorption_isotherm\Lys_P-adsorption_isotherms_KB_without_blank_subtracted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noSoilPhos\Lys_P-adsorption_isotherm\Lys_P-adsorption_isotherms_KB_without_blank_subtract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de-DE" sz="1600" dirty="0" err="1"/>
              <a:t>toe</a:t>
            </a:r>
            <a:r>
              <a:rPr lang="de-DE" sz="1600" dirty="0"/>
              <a:t> slope-1</a:t>
            </a:r>
          </a:p>
        </c:rich>
      </c:tx>
      <c:layout>
        <c:manualLayout>
          <c:xMode val="edge"/>
          <c:yMode val="edge"/>
          <c:x val="0.15876332070093613"/>
          <c:y val="3.203275306014332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037994364007385"/>
          <c:y val="4.0018092874691352E-2"/>
          <c:w val="0.78612412140057653"/>
          <c:h val="0.75308216681248175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KB286'!$G$46:$G$78</c:f>
                <c:numCache>
                  <c:formatCode>General</c:formatCode>
                  <c:ptCount val="33"/>
                  <c:pt idx="0">
                    <c:v>1.3281909470811969E-2</c:v>
                  </c:pt>
                  <c:pt idx="3">
                    <c:v>4.0642690586645512E-3</c:v>
                  </c:pt>
                  <c:pt idx="6">
                    <c:v>2.6933188729227661E-2</c:v>
                  </c:pt>
                  <c:pt idx="9">
                    <c:v>1.6627317474347345E-2</c:v>
                  </c:pt>
                  <c:pt idx="12">
                    <c:v>3.2628598461887093E-2</c:v>
                  </c:pt>
                  <c:pt idx="15">
                    <c:v>4.8462968524482668E-2</c:v>
                  </c:pt>
                  <c:pt idx="18">
                    <c:v>0.15500403903265819</c:v>
                  </c:pt>
                  <c:pt idx="21">
                    <c:v>0.13323769393723667</c:v>
                  </c:pt>
                  <c:pt idx="24">
                    <c:v>7.2859728619404263E-2</c:v>
                  </c:pt>
                  <c:pt idx="27">
                    <c:v>0.51346595028301767</c:v>
                  </c:pt>
                  <c:pt idx="30">
                    <c:v>0.49926597146112672</c:v>
                  </c:pt>
                </c:numCache>
              </c:numRef>
            </c:plus>
            <c:minus>
              <c:numRef>
                <c:f>'KB286'!$G$46:$G$78</c:f>
                <c:numCache>
                  <c:formatCode>General</c:formatCode>
                  <c:ptCount val="33"/>
                  <c:pt idx="0">
                    <c:v>1.3281909470811969E-2</c:v>
                  </c:pt>
                  <c:pt idx="3">
                    <c:v>4.0642690586645512E-3</c:v>
                  </c:pt>
                  <c:pt idx="6">
                    <c:v>2.6933188729227661E-2</c:v>
                  </c:pt>
                  <c:pt idx="9">
                    <c:v>1.6627317474347345E-2</c:v>
                  </c:pt>
                  <c:pt idx="12">
                    <c:v>3.2628598461887093E-2</c:v>
                  </c:pt>
                  <c:pt idx="15">
                    <c:v>4.8462968524482668E-2</c:v>
                  </c:pt>
                  <c:pt idx="18">
                    <c:v>0.15500403903265819</c:v>
                  </c:pt>
                  <c:pt idx="21">
                    <c:v>0.13323769393723667</c:v>
                  </c:pt>
                  <c:pt idx="24">
                    <c:v>7.2859728619404263E-2</c:v>
                  </c:pt>
                  <c:pt idx="27">
                    <c:v>0.51346595028301767</c:v>
                  </c:pt>
                  <c:pt idx="30">
                    <c:v>0.49926597146112672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0"/>
            <c:plus>
              <c:numRef>
                <c:f>'KB286'!$J$46:$J$78</c:f>
                <c:numCache>
                  <c:formatCode>General</c:formatCode>
                  <c:ptCount val="33"/>
                  <c:pt idx="0">
                    <c:v>0.3320477367702992</c:v>
                  </c:pt>
                  <c:pt idx="3">
                    <c:v>0.10160672646661482</c:v>
                  </c:pt>
                  <c:pt idx="6">
                    <c:v>0.67332971823069332</c:v>
                  </c:pt>
                  <c:pt idx="9">
                    <c:v>0.41568293685868407</c:v>
                  </c:pt>
                  <c:pt idx="12">
                    <c:v>0.8157149615471756</c:v>
                  </c:pt>
                  <c:pt idx="15">
                    <c:v>1.2115742131120679</c:v>
                  </c:pt>
                  <c:pt idx="18">
                    <c:v>3.8751009758164616</c:v>
                  </c:pt>
                  <c:pt idx="21">
                    <c:v>3.3309423484309133</c:v>
                  </c:pt>
                  <c:pt idx="24">
                    <c:v>1.8214932154851045</c:v>
                  </c:pt>
                  <c:pt idx="27">
                    <c:v>12.83664875707545</c:v>
                  </c:pt>
                  <c:pt idx="30">
                    <c:v>12.481649286528175</c:v>
                  </c:pt>
                </c:numCache>
              </c:numRef>
            </c:plus>
            <c:minus>
              <c:numRef>
                <c:f>'KB286'!$J$46:$J$78</c:f>
                <c:numCache>
                  <c:formatCode>General</c:formatCode>
                  <c:ptCount val="33"/>
                  <c:pt idx="0">
                    <c:v>0.3320477367702992</c:v>
                  </c:pt>
                  <c:pt idx="3">
                    <c:v>0.10160672646661482</c:v>
                  </c:pt>
                  <c:pt idx="6">
                    <c:v>0.67332971823069332</c:v>
                  </c:pt>
                  <c:pt idx="9">
                    <c:v>0.41568293685868407</c:v>
                  </c:pt>
                  <c:pt idx="12">
                    <c:v>0.8157149615471756</c:v>
                  </c:pt>
                  <c:pt idx="15">
                    <c:v>1.2115742131120679</c:v>
                  </c:pt>
                  <c:pt idx="18">
                    <c:v>3.8751009758164616</c:v>
                  </c:pt>
                  <c:pt idx="21">
                    <c:v>3.3309423484309133</c:v>
                  </c:pt>
                  <c:pt idx="24">
                    <c:v>1.8214932154851045</c:v>
                  </c:pt>
                  <c:pt idx="27">
                    <c:v>12.83664875707545</c:v>
                  </c:pt>
                  <c:pt idx="30">
                    <c:v>12.481649286528175</c:v>
                  </c:pt>
                </c:numCache>
              </c:numRef>
            </c:minus>
          </c:errBars>
          <c:xVal>
            <c:numRef>
              <c:f>'KB286'!$F$46:$F$78</c:f>
              <c:numCache>
                <c:formatCode>General</c:formatCode>
                <c:ptCount val="33"/>
                <c:pt idx="0" formatCode="0.0000">
                  <c:v>0.295339889841368</c:v>
                </c:pt>
                <c:pt idx="3" formatCode="0.0000">
                  <c:v>0.48032363839564329</c:v>
                </c:pt>
                <c:pt idx="6" formatCode="0.0000">
                  <c:v>0.70312479925850635</c:v>
                </c:pt>
                <c:pt idx="9" formatCode="0.0000">
                  <c:v>1.0067270358775973</c:v>
                </c:pt>
                <c:pt idx="12" formatCode="0.0000">
                  <c:v>1.9101158370008937</c:v>
                </c:pt>
                <c:pt idx="15" formatCode="0.0000">
                  <c:v>3.0275140624754706</c:v>
                </c:pt>
                <c:pt idx="18" formatCode="0.0000">
                  <c:v>6.8616932910053139</c:v>
                </c:pt>
                <c:pt idx="21" formatCode="0.0000">
                  <c:v>11.411943691729865</c:v>
                </c:pt>
                <c:pt idx="24" formatCode="0.0000">
                  <c:v>15.761171846142851</c:v>
                </c:pt>
                <c:pt idx="27" formatCode="0.0000">
                  <c:v>24.201415431931668</c:v>
                </c:pt>
                <c:pt idx="30" formatCode="0.0000">
                  <c:v>40.950226679676469</c:v>
                </c:pt>
              </c:numCache>
            </c:numRef>
          </c:xVal>
          <c:yVal>
            <c:numRef>
              <c:f>'KB286'!$I$46:$I$78</c:f>
              <c:numCache>
                <c:formatCode>General</c:formatCode>
                <c:ptCount val="33"/>
                <c:pt idx="0" formatCode="0.00">
                  <c:v>5.1165027539658006</c:v>
                </c:pt>
                <c:pt idx="3" formatCode="0.00">
                  <c:v>12.99190904010892</c:v>
                </c:pt>
                <c:pt idx="6" formatCode="0.00">
                  <c:v>19.92188001853734</c:v>
                </c:pt>
                <c:pt idx="9" formatCode="0.00">
                  <c:v>24.831824103060072</c:v>
                </c:pt>
                <c:pt idx="12" formatCode="0.00">
                  <c:v>39.747104074977663</c:v>
                </c:pt>
                <c:pt idx="15" formatCode="0.00">
                  <c:v>49.31214843811324</c:v>
                </c:pt>
                <c:pt idx="18" formatCode="0.00">
                  <c:v>78.45766772486715</c:v>
                </c:pt>
                <c:pt idx="21" formatCode="0.00">
                  <c:v>89.7014077067534</c:v>
                </c:pt>
                <c:pt idx="24" formatCode="0.00">
                  <c:v>105.97070384642872</c:v>
                </c:pt>
                <c:pt idx="27" formatCode="0.00">
                  <c:v>144.96461420170829</c:v>
                </c:pt>
                <c:pt idx="30" formatCode="0.00">
                  <c:v>226.244333008088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AA4-4E5D-97A2-76ED438DE0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13536"/>
        <c:axId val="287714112"/>
      </c:scatterChart>
      <c:valAx>
        <c:axId val="287713536"/>
        <c:scaling>
          <c:orientation val="minMax"/>
          <c:max val="5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quilibrium P concentration [mg </a:t>
                </a:r>
                <a:r>
                  <a:rPr lang="en-US" sz="1000" b="1" i="0" u="none" strike="noStrike" baseline="0" dirty="0">
                    <a:effectLst/>
                  </a:rPr>
                  <a:t>L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4112"/>
        <c:crosses val="autoZero"/>
        <c:crossBetween val="midCat"/>
      </c:valAx>
      <c:valAx>
        <c:axId val="287714112"/>
        <c:scaling>
          <c:orientation val="minMax"/>
          <c:max val="3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 adsorbed [mg kg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layout>
            <c:manualLayout>
              <c:xMode val="edge"/>
              <c:yMode val="edge"/>
              <c:x val="0"/>
              <c:y val="0.12794151209754456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3536"/>
        <c:crosses val="autoZero"/>
        <c:crossBetween val="midCat"/>
        <c:majorUnit val="5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sz="1600" dirty="0" err="1"/>
              <a:t>toe</a:t>
            </a:r>
            <a:r>
              <a:rPr lang="de-DE" sz="1600" baseline="0" dirty="0"/>
              <a:t> slope-</a:t>
            </a:r>
            <a:r>
              <a:rPr lang="de-DE" sz="1600" dirty="0"/>
              <a:t>2</a:t>
            </a:r>
          </a:p>
        </c:rich>
      </c:tx>
      <c:layout>
        <c:manualLayout>
          <c:xMode val="edge"/>
          <c:yMode val="edge"/>
          <c:x val="0.2041685151169626"/>
          <c:y val="6.9444476882280698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KB287'!$G$46:$G$78</c:f>
                <c:numCache>
                  <c:formatCode>General</c:formatCode>
                  <c:ptCount val="33"/>
                  <c:pt idx="0">
                    <c:v>3.1941378751261492E-3</c:v>
                  </c:pt>
                  <c:pt idx="3">
                    <c:v>9.7642317943983838E-3</c:v>
                  </c:pt>
                  <c:pt idx="6">
                    <c:v>1.5369332140635591E-3</c:v>
                  </c:pt>
                  <c:pt idx="9">
                    <c:v>1.3092053003307897E-2</c:v>
                  </c:pt>
                  <c:pt idx="12">
                    <c:v>1.6583268972619834E-2</c:v>
                  </c:pt>
                  <c:pt idx="15">
                    <c:v>1.4278286375752357E-2</c:v>
                  </c:pt>
                  <c:pt idx="18">
                    <c:v>5.1390482438530304E-2</c:v>
                  </c:pt>
                  <c:pt idx="21">
                    <c:v>3.2833736617046451E-2</c:v>
                  </c:pt>
                  <c:pt idx="24">
                    <c:v>0.27112989995390108</c:v>
                  </c:pt>
                  <c:pt idx="27">
                    <c:v>0.47903475900054848</c:v>
                  </c:pt>
                  <c:pt idx="30">
                    <c:v>0.40245667387703965</c:v>
                  </c:pt>
                </c:numCache>
              </c:numRef>
            </c:plus>
            <c:minus>
              <c:numRef>
                <c:f>'KB287'!$G$46:$G$78</c:f>
                <c:numCache>
                  <c:formatCode>General</c:formatCode>
                  <c:ptCount val="33"/>
                  <c:pt idx="0">
                    <c:v>3.1941378751261492E-3</c:v>
                  </c:pt>
                  <c:pt idx="3">
                    <c:v>9.7642317943983838E-3</c:v>
                  </c:pt>
                  <c:pt idx="6">
                    <c:v>1.5369332140635591E-3</c:v>
                  </c:pt>
                  <c:pt idx="9">
                    <c:v>1.3092053003307897E-2</c:v>
                  </c:pt>
                  <c:pt idx="12">
                    <c:v>1.6583268972619834E-2</c:v>
                  </c:pt>
                  <c:pt idx="15">
                    <c:v>1.4278286375752357E-2</c:v>
                  </c:pt>
                  <c:pt idx="18">
                    <c:v>5.1390482438530304E-2</c:v>
                  </c:pt>
                  <c:pt idx="21">
                    <c:v>3.2833736617046451E-2</c:v>
                  </c:pt>
                  <c:pt idx="24">
                    <c:v>0.27112989995390108</c:v>
                  </c:pt>
                  <c:pt idx="27">
                    <c:v>0.47903475900054848</c:v>
                  </c:pt>
                  <c:pt idx="30">
                    <c:v>0.40245667387703965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0"/>
            <c:plus>
              <c:numRef>
                <c:f>'KB287'!$J$46:$J$78</c:f>
                <c:numCache>
                  <c:formatCode>General</c:formatCode>
                  <c:ptCount val="33"/>
                  <c:pt idx="0">
                    <c:v>7.9853446878154363E-2</c:v>
                  </c:pt>
                  <c:pt idx="3">
                    <c:v>0.24410579485995917</c:v>
                  </c:pt>
                  <c:pt idx="6">
                    <c:v>3.8423330351588271E-2</c:v>
                  </c:pt>
                  <c:pt idx="9">
                    <c:v>0.32730132508269899</c:v>
                  </c:pt>
                  <c:pt idx="12">
                    <c:v>0.41458172431549251</c:v>
                  </c:pt>
                  <c:pt idx="15">
                    <c:v>0.35695715939380429</c:v>
                  </c:pt>
                  <c:pt idx="18">
                    <c:v>1.2847620609632542</c:v>
                  </c:pt>
                  <c:pt idx="21">
                    <c:v>0.82084341542616213</c:v>
                  </c:pt>
                  <c:pt idx="24">
                    <c:v>6.7782474988475272</c:v>
                  </c:pt>
                  <c:pt idx="27">
                    <c:v>11.975868975013725</c:v>
                  </c:pt>
                  <c:pt idx="30">
                    <c:v>10.061416846926001</c:v>
                  </c:pt>
                </c:numCache>
              </c:numRef>
            </c:plus>
            <c:minus>
              <c:numRef>
                <c:f>'KB287'!$J$46:$J$78</c:f>
                <c:numCache>
                  <c:formatCode>General</c:formatCode>
                  <c:ptCount val="33"/>
                  <c:pt idx="0">
                    <c:v>7.9853446878154363E-2</c:v>
                  </c:pt>
                  <c:pt idx="3">
                    <c:v>0.24410579485995917</c:v>
                  </c:pt>
                  <c:pt idx="6">
                    <c:v>3.8423330351588271E-2</c:v>
                  </c:pt>
                  <c:pt idx="9">
                    <c:v>0.32730132508269899</c:v>
                  </c:pt>
                  <c:pt idx="12">
                    <c:v>0.41458172431549251</c:v>
                  </c:pt>
                  <c:pt idx="15">
                    <c:v>0.35695715939380429</c:v>
                  </c:pt>
                  <c:pt idx="18">
                    <c:v>1.2847620609632542</c:v>
                  </c:pt>
                  <c:pt idx="21">
                    <c:v>0.82084341542616213</c:v>
                  </c:pt>
                  <c:pt idx="24">
                    <c:v>6.7782474988475272</c:v>
                  </c:pt>
                  <c:pt idx="27">
                    <c:v>11.975868975013725</c:v>
                  </c:pt>
                  <c:pt idx="30">
                    <c:v>10.061416846926001</c:v>
                  </c:pt>
                </c:numCache>
              </c:numRef>
            </c:minus>
          </c:errBars>
          <c:xVal>
            <c:numRef>
              <c:f>'KB287'!$F$46:$F$78</c:f>
              <c:numCache>
                <c:formatCode>General</c:formatCode>
                <c:ptCount val="33"/>
                <c:pt idx="0" formatCode="0.0000">
                  <c:v>4.9178721782249392E-2</c:v>
                </c:pt>
                <c:pt idx="3" formatCode="0.0000">
                  <c:v>0.13871203429815479</c:v>
                </c:pt>
                <c:pt idx="6" formatCode="0.0000">
                  <c:v>0.28022993665168888</c:v>
                </c:pt>
                <c:pt idx="9" formatCode="0.0000">
                  <c:v>0.46394476651147859</c:v>
                </c:pt>
                <c:pt idx="12" formatCode="0.0000">
                  <c:v>1.2193945071054797</c:v>
                </c:pt>
                <c:pt idx="15" formatCode="0.0000">
                  <c:v>2.2282406293432704</c:v>
                </c:pt>
                <c:pt idx="18" formatCode="0.0000">
                  <c:v>6.2450745819429718</c:v>
                </c:pt>
                <c:pt idx="21" formatCode="0.0000">
                  <c:v>10.818726183128874</c:v>
                </c:pt>
                <c:pt idx="24" formatCode="0.0000">
                  <c:v>15.345917940181186</c:v>
                </c:pt>
                <c:pt idx="27" formatCode="0.0000">
                  <c:v>24.530112257228353</c:v>
                </c:pt>
                <c:pt idx="30" formatCode="0.0000">
                  <c:v>43.521842199910814</c:v>
                </c:pt>
              </c:numCache>
            </c:numRef>
          </c:xVal>
          <c:yVal>
            <c:numRef>
              <c:f>'KB287'!$I$46:$I$78</c:f>
              <c:numCache>
                <c:formatCode>General</c:formatCode>
                <c:ptCount val="33"/>
                <c:pt idx="0" formatCode="0.00">
                  <c:v>11.270531955443765</c:v>
                </c:pt>
                <c:pt idx="3" formatCode="0.00">
                  <c:v>21.53219914254613</c:v>
                </c:pt>
                <c:pt idx="6" formatCode="0.00">
                  <c:v>30.494251583707779</c:v>
                </c:pt>
                <c:pt idx="9" formatCode="0.00">
                  <c:v>38.401380837213033</c:v>
                </c:pt>
                <c:pt idx="12" formatCode="0.00">
                  <c:v>57.01513732236301</c:v>
                </c:pt>
                <c:pt idx="15" formatCode="0.00">
                  <c:v>69.293984266418249</c:v>
                </c:pt>
                <c:pt idx="18" formatCode="0.00">
                  <c:v>93.873135451425739</c:v>
                </c:pt>
                <c:pt idx="21" formatCode="0.00">
                  <c:v>104.53184542177816</c:v>
                </c:pt>
                <c:pt idx="24" formatCode="0.00">
                  <c:v>116.35205149547039</c:v>
                </c:pt>
                <c:pt idx="27" formatCode="0.00">
                  <c:v>136.74719356929117</c:v>
                </c:pt>
                <c:pt idx="30" formatCode="0.00">
                  <c:v>161.9539450022295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330-41F9-9C0C-F02F1B2C56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13536"/>
        <c:axId val="287714112"/>
      </c:scatterChart>
      <c:valAx>
        <c:axId val="2877135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quilibrium P concentration [mg </a:t>
                </a:r>
                <a:r>
                  <a:rPr lang="en-US" sz="1000" b="1" i="0" u="none" strike="noStrike" baseline="0" dirty="0">
                    <a:effectLst/>
                  </a:rPr>
                  <a:t>L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4112"/>
        <c:crosses val="autoZero"/>
        <c:crossBetween val="midCat"/>
      </c:valAx>
      <c:valAx>
        <c:axId val="287714112"/>
        <c:scaling>
          <c:orientation val="minMax"/>
          <c:max val="3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 adsorbed [mg </a:t>
                </a:r>
                <a:r>
                  <a:rPr lang="en-US" sz="1000" b="1" i="0" u="none" strike="noStrike" baseline="0" dirty="0">
                    <a:effectLst/>
                  </a:rPr>
                  <a:t>kg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3536"/>
        <c:crosses val="autoZero"/>
        <c:crossBetween val="midCat"/>
        <c:majorUnit val="5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sz="1600" dirty="0" err="1"/>
              <a:t>toe</a:t>
            </a:r>
            <a:r>
              <a:rPr lang="de-DE" sz="1600" dirty="0"/>
              <a:t> slope-3</a:t>
            </a:r>
          </a:p>
        </c:rich>
      </c:tx>
      <c:layout>
        <c:manualLayout>
          <c:xMode val="edge"/>
          <c:yMode val="edge"/>
          <c:x val="0.20277462507954294"/>
          <c:y val="5.0529763225961338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KB289'!$G$46:$G$78</c:f>
                <c:numCache>
                  <c:formatCode>General</c:formatCode>
                  <c:ptCount val="33"/>
                  <c:pt idx="0">
                    <c:v>3.6683328899843395E-3</c:v>
                  </c:pt>
                  <c:pt idx="3">
                    <c:v>1.363139649734045E-3</c:v>
                  </c:pt>
                  <c:pt idx="6">
                    <c:v>1.677433642926458E-2</c:v>
                  </c:pt>
                  <c:pt idx="9">
                    <c:v>1.0070415350324052E-2</c:v>
                  </c:pt>
                  <c:pt idx="12">
                    <c:v>2.4121912057317084E-2</c:v>
                  </c:pt>
                  <c:pt idx="15">
                    <c:v>2.7459654600332097E-2</c:v>
                  </c:pt>
                  <c:pt idx="18">
                    <c:v>0.17841435100202657</c:v>
                  </c:pt>
                  <c:pt idx="21">
                    <c:v>0.18053276462134424</c:v>
                  </c:pt>
                  <c:pt idx="24">
                    <c:v>0.12667001538589384</c:v>
                  </c:pt>
                  <c:pt idx="27">
                    <c:v>0.19953070577930682</c:v>
                  </c:pt>
                  <c:pt idx="30">
                    <c:v>0.25034107753715595</c:v>
                  </c:pt>
                </c:numCache>
              </c:numRef>
            </c:plus>
            <c:minus>
              <c:numRef>
                <c:f>'KB289'!$G$46:$G$78</c:f>
                <c:numCache>
                  <c:formatCode>General</c:formatCode>
                  <c:ptCount val="33"/>
                  <c:pt idx="0">
                    <c:v>3.6683328899843395E-3</c:v>
                  </c:pt>
                  <c:pt idx="3">
                    <c:v>1.363139649734045E-3</c:v>
                  </c:pt>
                  <c:pt idx="6">
                    <c:v>1.677433642926458E-2</c:v>
                  </c:pt>
                  <c:pt idx="9">
                    <c:v>1.0070415350324052E-2</c:v>
                  </c:pt>
                  <c:pt idx="12">
                    <c:v>2.4121912057317084E-2</c:v>
                  </c:pt>
                  <c:pt idx="15">
                    <c:v>2.7459654600332097E-2</c:v>
                  </c:pt>
                  <c:pt idx="18">
                    <c:v>0.17841435100202657</c:v>
                  </c:pt>
                  <c:pt idx="21">
                    <c:v>0.18053276462134424</c:v>
                  </c:pt>
                  <c:pt idx="24">
                    <c:v>0.12667001538589384</c:v>
                  </c:pt>
                  <c:pt idx="27">
                    <c:v>0.19953070577930682</c:v>
                  </c:pt>
                  <c:pt idx="30">
                    <c:v>0.25034107753715595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0"/>
            <c:plus>
              <c:numRef>
                <c:f>'KB289'!$J$46:$J$78</c:f>
                <c:numCache>
                  <c:formatCode>General</c:formatCode>
                  <c:ptCount val="33"/>
                  <c:pt idx="0">
                    <c:v>9.1708322249608398E-2</c:v>
                  </c:pt>
                  <c:pt idx="3">
                    <c:v>3.4078491243351272E-2</c:v>
                  </c:pt>
                  <c:pt idx="6">
                    <c:v>0.41935841073161456</c:v>
                  </c:pt>
                  <c:pt idx="9">
                    <c:v>0.25176038375809973</c:v>
                  </c:pt>
                  <c:pt idx="12">
                    <c:v>0.60304780143292558</c:v>
                  </c:pt>
                  <c:pt idx="15">
                    <c:v>0.68649136500830454</c:v>
                  </c:pt>
                  <c:pt idx="18">
                    <c:v>4.460358775050671</c:v>
                  </c:pt>
                  <c:pt idx="21">
                    <c:v>4.5133191155336121</c:v>
                  </c:pt>
                  <c:pt idx="24">
                    <c:v>3.1667503846473455</c:v>
                  </c:pt>
                  <c:pt idx="27">
                    <c:v>4.9882676444826748</c:v>
                  </c:pt>
                  <c:pt idx="30">
                    <c:v>6.2585269384289095</c:v>
                  </c:pt>
                </c:numCache>
              </c:numRef>
            </c:plus>
            <c:minus>
              <c:numRef>
                <c:f>'KB289'!$J$46:$J$78</c:f>
                <c:numCache>
                  <c:formatCode>General</c:formatCode>
                  <c:ptCount val="33"/>
                  <c:pt idx="0">
                    <c:v>9.1708322249608398E-2</c:v>
                  </c:pt>
                  <c:pt idx="3">
                    <c:v>3.4078491243351272E-2</c:v>
                  </c:pt>
                  <c:pt idx="6">
                    <c:v>0.41935841073161456</c:v>
                  </c:pt>
                  <c:pt idx="9">
                    <c:v>0.25176038375809973</c:v>
                  </c:pt>
                  <c:pt idx="12">
                    <c:v>0.60304780143292558</c:v>
                  </c:pt>
                  <c:pt idx="15">
                    <c:v>0.68649136500830454</c:v>
                  </c:pt>
                  <c:pt idx="18">
                    <c:v>4.460358775050671</c:v>
                  </c:pt>
                  <c:pt idx="21">
                    <c:v>4.5133191155336121</c:v>
                  </c:pt>
                  <c:pt idx="24">
                    <c:v>3.1667503846473455</c:v>
                  </c:pt>
                  <c:pt idx="27">
                    <c:v>4.9882676444826748</c:v>
                  </c:pt>
                  <c:pt idx="30">
                    <c:v>6.2585269384289095</c:v>
                  </c:pt>
                </c:numCache>
              </c:numRef>
            </c:minus>
          </c:errBars>
          <c:xVal>
            <c:numRef>
              <c:f>'KB288'!$F$46:$F$78</c:f>
              <c:numCache>
                <c:formatCode>General</c:formatCode>
                <c:ptCount val="33"/>
                <c:pt idx="0" formatCode="0.0000">
                  <c:v>4.891578418205627E-2</c:v>
                </c:pt>
                <c:pt idx="3" formatCode="0.0000">
                  <c:v>0.20915385222404156</c:v>
                </c:pt>
                <c:pt idx="6" formatCode="0.0000">
                  <c:v>0.41881780932909402</c:v>
                </c:pt>
                <c:pt idx="9" formatCode="0.0000">
                  <c:v>0.64978134971404067</c:v>
                </c:pt>
                <c:pt idx="12" formatCode="0.0000">
                  <c:v>1.6528240960841736</c:v>
                </c:pt>
                <c:pt idx="15" formatCode="0.0000">
                  <c:v>2.7684026341967964</c:v>
                </c:pt>
                <c:pt idx="18" formatCode="0.0000">
                  <c:v>6.628062748950839</c:v>
                </c:pt>
                <c:pt idx="21" formatCode="0.0000">
                  <c:v>10.441583031872609</c:v>
                </c:pt>
                <c:pt idx="24" formatCode="0.0000">
                  <c:v>14.653094671006839</c:v>
                </c:pt>
                <c:pt idx="27" formatCode="0.0000">
                  <c:v>21.90363309735606</c:v>
                </c:pt>
                <c:pt idx="30" formatCode="0.0000">
                  <c:v>37.337777764385187</c:v>
                </c:pt>
              </c:numCache>
            </c:numRef>
          </c:xVal>
          <c:yVal>
            <c:numRef>
              <c:f>'KB288'!$I$46:$I$78</c:f>
              <c:numCache>
                <c:formatCode>General</c:formatCode>
                <c:ptCount val="33"/>
                <c:pt idx="0" formatCode="0.00">
                  <c:v>11.277105395448594</c:v>
                </c:pt>
                <c:pt idx="3" formatCode="0.00">
                  <c:v>19.771153694398965</c:v>
                </c:pt>
                <c:pt idx="6" formatCode="0.00">
                  <c:v>27.029554766772652</c:v>
                </c:pt>
                <c:pt idx="9" formatCode="0.00">
                  <c:v>33.755466257148989</c:v>
                </c:pt>
                <c:pt idx="12" formatCode="0.00">
                  <c:v>46.179397597895665</c:v>
                </c:pt>
                <c:pt idx="15" formatCode="0.00">
                  <c:v>55.789934145080089</c:v>
                </c:pt>
                <c:pt idx="18" formatCode="0.00">
                  <c:v>84.298431276229039</c:v>
                </c:pt>
                <c:pt idx="21" formatCode="0.00">
                  <c:v>113.9604242031848</c:v>
                </c:pt>
                <c:pt idx="24" formatCode="0.00">
                  <c:v>133.67263322482907</c:v>
                </c:pt>
                <c:pt idx="27" formatCode="0.00">
                  <c:v>202.40917256609853</c:v>
                </c:pt>
                <c:pt idx="30" formatCode="0.00">
                  <c:v>316.555555890370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6BD-448D-9E72-B204F08C72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13536"/>
        <c:axId val="287714112"/>
      </c:scatterChart>
      <c:valAx>
        <c:axId val="287713536"/>
        <c:scaling>
          <c:orientation val="minMax"/>
          <c:max val="5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quilibrium P concentration</a:t>
                </a:r>
                <a:r>
                  <a:rPr lang="en-US" baseline="0" dirty="0"/>
                  <a:t> </a:t>
                </a:r>
                <a:r>
                  <a:rPr lang="en-US" dirty="0"/>
                  <a:t>[mg </a:t>
                </a:r>
                <a:r>
                  <a:rPr lang="en-US" sz="1000" b="1" i="0" u="none" strike="noStrike" baseline="0" dirty="0">
                    <a:effectLst/>
                  </a:rPr>
                  <a:t>L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4112"/>
        <c:crosses val="autoZero"/>
        <c:crossBetween val="midCat"/>
      </c:valAx>
      <c:valAx>
        <c:axId val="2877141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 adsorbed [mg </a:t>
                </a:r>
                <a:r>
                  <a:rPr lang="en-US" sz="1000" b="1" i="0" u="none" strike="noStrike" baseline="0" dirty="0">
                    <a:effectLst/>
                  </a:rPr>
                  <a:t>kg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3536"/>
        <c:crosses val="autoZero"/>
        <c:crossBetween val="midCat"/>
        <c:majorUnit val="5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sz="1600" dirty="0" err="1"/>
              <a:t>mid</a:t>
            </a:r>
            <a:r>
              <a:rPr lang="de-DE" sz="1600" dirty="0"/>
              <a:t> slope-1</a:t>
            </a:r>
          </a:p>
        </c:rich>
      </c:tx>
      <c:layout>
        <c:manualLayout>
          <c:xMode val="edge"/>
          <c:yMode val="edge"/>
          <c:x val="0.16785799872472246"/>
          <c:y val="2.547510552880581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038005890874371"/>
          <c:y val="3.2766477107028277E-2"/>
          <c:w val="0.79023759246986269"/>
          <c:h val="0.75308216681248175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KB289'!$G$46:$G$78</c:f>
                <c:numCache>
                  <c:formatCode>General</c:formatCode>
                  <c:ptCount val="33"/>
                  <c:pt idx="0">
                    <c:v>3.6683328899843395E-3</c:v>
                  </c:pt>
                  <c:pt idx="3">
                    <c:v>1.363139649734045E-3</c:v>
                  </c:pt>
                  <c:pt idx="6">
                    <c:v>1.677433642926458E-2</c:v>
                  </c:pt>
                  <c:pt idx="9">
                    <c:v>1.0070415350324052E-2</c:v>
                  </c:pt>
                  <c:pt idx="12">
                    <c:v>2.4121912057317084E-2</c:v>
                  </c:pt>
                  <c:pt idx="15">
                    <c:v>2.7459654600332097E-2</c:v>
                  </c:pt>
                  <c:pt idx="18">
                    <c:v>0.17841435100202657</c:v>
                  </c:pt>
                  <c:pt idx="21">
                    <c:v>0.18053276462134424</c:v>
                  </c:pt>
                  <c:pt idx="24">
                    <c:v>0.12667001538589384</c:v>
                  </c:pt>
                  <c:pt idx="27">
                    <c:v>0.19953070577930682</c:v>
                  </c:pt>
                  <c:pt idx="30">
                    <c:v>0.25034107753715595</c:v>
                  </c:pt>
                </c:numCache>
              </c:numRef>
            </c:plus>
            <c:minus>
              <c:numRef>
                <c:f>'KB289'!$G$46:$G$78</c:f>
                <c:numCache>
                  <c:formatCode>General</c:formatCode>
                  <c:ptCount val="33"/>
                  <c:pt idx="0">
                    <c:v>3.6683328899843395E-3</c:v>
                  </c:pt>
                  <c:pt idx="3">
                    <c:v>1.363139649734045E-3</c:v>
                  </c:pt>
                  <c:pt idx="6">
                    <c:v>1.677433642926458E-2</c:v>
                  </c:pt>
                  <c:pt idx="9">
                    <c:v>1.0070415350324052E-2</c:v>
                  </c:pt>
                  <c:pt idx="12">
                    <c:v>2.4121912057317084E-2</c:v>
                  </c:pt>
                  <c:pt idx="15">
                    <c:v>2.7459654600332097E-2</c:v>
                  </c:pt>
                  <c:pt idx="18">
                    <c:v>0.17841435100202657</c:v>
                  </c:pt>
                  <c:pt idx="21">
                    <c:v>0.18053276462134424</c:v>
                  </c:pt>
                  <c:pt idx="24">
                    <c:v>0.12667001538589384</c:v>
                  </c:pt>
                  <c:pt idx="27">
                    <c:v>0.19953070577930682</c:v>
                  </c:pt>
                  <c:pt idx="30">
                    <c:v>0.25034107753715595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0"/>
            <c:plus>
              <c:numRef>
                <c:f>'KB289'!$J$46:$J$78</c:f>
                <c:numCache>
                  <c:formatCode>General</c:formatCode>
                  <c:ptCount val="33"/>
                  <c:pt idx="0">
                    <c:v>9.1708322249608398E-2</c:v>
                  </c:pt>
                  <c:pt idx="3">
                    <c:v>3.4078491243351272E-2</c:v>
                  </c:pt>
                  <c:pt idx="6">
                    <c:v>0.41935841073161456</c:v>
                  </c:pt>
                  <c:pt idx="9">
                    <c:v>0.25176038375809973</c:v>
                  </c:pt>
                  <c:pt idx="12">
                    <c:v>0.60304780143292558</c:v>
                  </c:pt>
                  <c:pt idx="15">
                    <c:v>0.68649136500830454</c:v>
                  </c:pt>
                  <c:pt idx="18">
                    <c:v>4.460358775050671</c:v>
                  </c:pt>
                  <c:pt idx="21">
                    <c:v>4.5133191155336121</c:v>
                  </c:pt>
                  <c:pt idx="24">
                    <c:v>3.1667503846473455</c:v>
                  </c:pt>
                  <c:pt idx="27">
                    <c:v>4.9882676444826748</c:v>
                  </c:pt>
                  <c:pt idx="30">
                    <c:v>6.2585269384289095</c:v>
                  </c:pt>
                </c:numCache>
              </c:numRef>
            </c:plus>
            <c:minus>
              <c:numRef>
                <c:f>'KB289'!$J$46:$J$78</c:f>
                <c:numCache>
                  <c:formatCode>General</c:formatCode>
                  <c:ptCount val="33"/>
                  <c:pt idx="0">
                    <c:v>9.1708322249608398E-2</c:v>
                  </c:pt>
                  <c:pt idx="3">
                    <c:v>3.4078491243351272E-2</c:v>
                  </c:pt>
                  <c:pt idx="6">
                    <c:v>0.41935841073161456</c:v>
                  </c:pt>
                  <c:pt idx="9">
                    <c:v>0.25176038375809973</c:v>
                  </c:pt>
                  <c:pt idx="12">
                    <c:v>0.60304780143292558</c:v>
                  </c:pt>
                  <c:pt idx="15">
                    <c:v>0.68649136500830454</c:v>
                  </c:pt>
                  <c:pt idx="18">
                    <c:v>4.460358775050671</c:v>
                  </c:pt>
                  <c:pt idx="21">
                    <c:v>4.5133191155336121</c:v>
                  </c:pt>
                  <c:pt idx="24">
                    <c:v>3.1667503846473455</c:v>
                  </c:pt>
                  <c:pt idx="27">
                    <c:v>4.9882676444826748</c:v>
                  </c:pt>
                  <c:pt idx="30">
                    <c:v>6.2585269384289095</c:v>
                  </c:pt>
                </c:numCache>
              </c:numRef>
            </c:minus>
          </c:errBars>
          <c:xVal>
            <c:numRef>
              <c:f>'KB289'!$F$46:$F$78</c:f>
              <c:numCache>
                <c:formatCode>General</c:formatCode>
                <c:ptCount val="33"/>
                <c:pt idx="0" formatCode="0.0000">
                  <c:v>0.19876874482654042</c:v>
                </c:pt>
                <c:pt idx="3" formatCode="0.0000">
                  <c:v>0.33643005728861231</c:v>
                </c:pt>
                <c:pt idx="6" formatCode="0.0000">
                  <c:v>0.49828601515012733</c:v>
                </c:pt>
                <c:pt idx="9" formatCode="0.0000">
                  <c:v>0.7120258480216517</c:v>
                </c:pt>
                <c:pt idx="12" formatCode="0.0000">
                  <c:v>1.4842364600464935</c:v>
                </c:pt>
                <c:pt idx="15" formatCode="0.0000">
                  <c:v>2.3011702989822567</c:v>
                </c:pt>
                <c:pt idx="18" formatCode="0.0000">
                  <c:v>5.7443300718709773</c:v>
                </c:pt>
                <c:pt idx="21" formatCode="0.0000">
                  <c:v>9.4839644351602583</c:v>
                </c:pt>
                <c:pt idx="24" formatCode="0.0000">
                  <c:v>13.667441655818687</c:v>
                </c:pt>
                <c:pt idx="27" formatCode="0.0000">
                  <c:v>21.968935024619274</c:v>
                </c:pt>
                <c:pt idx="30" formatCode="0.0000">
                  <c:v>39.016324203017703</c:v>
                </c:pt>
              </c:numCache>
            </c:numRef>
          </c:xVal>
          <c:yVal>
            <c:numRef>
              <c:f>'KB289'!$I$46:$I$78</c:f>
              <c:numCache>
                <c:formatCode>General</c:formatCode>
                <c:ptCount val="33"/>
                <c:pt idx="0" formatCode="0.00">
                  <c:v>7.5307813793364886</c:v>
                </c:pt>
                <c:pt idx="3" formatCode="0.00">
                  <c:v>16.589248567784693</c:v>
                </c:pt>
                <c:pt idx="6" formatCode="0.00">
                  <c:v>25.04284962124682</c:v>
                </c:pt>
                <c:pt idx="9" formatCode="0.00">
                  <c:v>32.199353799458713</c:v>
                </c:pt>
                <c:pt idx="12" formatCode="0.00">
                  <c:v>50.394088498837668</c:v>
                </c:pt>
                <c:pt idx="15" formatCode="0.00">
                  <c:v>67.470742525443583</c:v>
                </c:pt>
                <c:pt idx="18" formatCode="0.00">
                  <c:v>106.39174820322556</c:v>
                </c:pt>
                <c:pt idx="21" formatCode="0.00">
                  <c:v>137.90088912099358</c:v>
                </c:pt>
                <c:pt idx="24" formatCode="0.00">
                  <c:v>158.31395860453287</c:v>
                </c:pt>
                <c:pt idx="27" formatCode="0.00">
                  <c:v>200.77662438451807</c:v>
                </c:pt>
                <c:pt idx="30" formatCode="0.00">
                  <c:v>274.591894924557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A34-4177-B367-DAEAAA3736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13536"/>
        <c:axId val="287714112"/>
      </c:scatterChart>
      <c:valAx>
        <c:axId val="287713536"/>
        <c:scaling>
          <c:orientation val="minMax"/>
          <c:max val="5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quilibrium P concentration [mg </a:t>
                </a:r>
                <a:r>
                  <a:rPr lang="en-US" sz="1000" b="1" i="0" u="none" strike="noStrike" baseline="0" dirty="0">
                    <a:effectLst/>
                  </a:rPr>
                  <a:t>L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4112"/>
        <c:crosses val="autoZero"/>
        <c:crossBetween val="midCat"/>
      </c:valAx>
      <c:valAx>
        <c:axId val="287714112"/>
        <c:scaling>
          <c:orientation val="minMax"/>
          <c:max val="3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 adsorbed [mg kg</a:t>
                </a:r>
                <a:r>
                  <a:rPr lang="en-US" baseline="30000" dirty="0"/>
                  <a:t>-1</a:t>
                </a:r>
                <a:r>
                  <a:rPr lang="en-US" dirty="0"/>
                  <a:t>]</a:t>
                </a:r>
              </a:p>
            </c:rich>
          </c:tx>
          <c:layout>
            <c:manualLayout>
              <c:xMode val="edge"/>
              <c:yMode val="edge"/>
              <c:x val="0"/>
              <c:y val="0.1279414460350859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3536"/>
        <c:crosses val="autoZero"/>
        <c:crossBetween val="midCat"/>
        <c:majorUnit val="5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sz="1600" dirty="0" err="1"/>
              <a:t>mid</a:t>
            </a:r>
            <a:r>
              <a:rPr lang="de-DE" sz="1600" dirty="0"/>
              <a:t> slope-2</a:t>
            </a:r>
          </a:p>
        </c:rich>
      </c:tx>
      <c:layout>
        <c:manualLayout>
          <c:xMode val="edge"/>
          <c:yMode val="edge"/>
          <c:x val="0.19661297083586035"/>
          <c:y val="6.9444476882280698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KB290'!$G$46:$G$78</c:f>
                <c:numCache>
                  <c:formatCode>General</c:formatCode>
                  <c:ptCount val="33"/>
                  <c:pt idx="0">
                    <c:v>1.0338554343981392E-2</c:v>
                  </c:pt>
                  <c:pt idx="3">
                    <c:v>2.4538904268399911E-3</c:v>
                  </c:pt>
                  <c:pt idx="6">
                    <c:v>6.5821532203588556E-3</c:v>
                  </c:pt>
                  <c:pt idx="9">
                    <c:v>3.9599277061036428E-3</c:v>
                  </c:pt>
                  <c:pt idx="12">
                    <c:v>6.8876054308404855E-3</c:v>
                  </c:pt>
                  <c:pt idx="15">
                    <c:v>3.8613577759654262E-3</c:v>
                  </c:pt>
                  <c:pt idx="18">
                    <c:v>6.0334150214643424E-2</c:v>
                  </c:pt>
                  <c:pt idx="21">
                    <c:v>0.13335083608864601</c:v>
                  </c:pt>
                  <c:pt idx="24">
                    <c:v>1.904005754427637</c:v>
                  </c:pt>
                  <c:pt idx="27">
                    <c:v>5.6050535525404302E-2</c:v>
                  </c:pt>
                  <c:pt idx="30">
                    <c:v>0.62522531907048451</c:v>
                  </c:pt>
                </c:numCache>
              </c:numRef>
            </c:plus>
            <c:minus>
              <c:numRef>
                <c:f>'KB290'!$G$46:$G$78</c:f>
                <c:numCache>
                  <c:formatCode>General</c:formatCode>
                  <c:ptCount val="33"/>
                  <c:pt idx="0">
                    <c:v>1.0338554343981392E-2</c:v>
                  </c:pt>
                  <c:pt idx="3">
                    <c:v>2.4538904268399911E-3</c:v>
                  </c:pt>
                  <c:pt idx="6">
                    <c:v>6.5821532203588556E-3</c:v>
                  </c:pt>
                  <c:pt idx="9">
                    <c:v>3.9599277061036428E-3</c:v>
                  </c:pt>
                  <c:pt idx="12">
                    <c:v>6.8876054308404855E-3</c:v>
                  </c:pt>
                  <c:pt idx="15">
                    <c:v>3.8613577759654262E-3</c:v>
                  </c:pt>
                  <c:pt idx="18">
                    <c:v>6.0334150214643424E-2</c:v>
                  </c:pt>
                  <c:pt idx="21">
                    <c:v>0.13335083608864601</c:v>
                  </c:pt>
                  <c:pt idx="24">
                    <c:v>1.904005754427637</c:v>
                  </c:pt>
                  <c:pt idx="27">
                    <c:v>5.6050535525404302E-2</c:v>
                  </c:pt>
                  <c:pt idx="30">
                    <c:v>0.62522531907048451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0"/>
            <c:plus>
              <c:numRef>
                <c:f>'KB290'!$J$46:$J$78</c:f>
                <c:numCache>
                  <c:formatCode>General</c:formatCode>
                  <c:ptCount val="33"/>
                  <c:pt idx="0">
                    <c:v>0.25846385859953336</c:v>
                  </c:pt>
                  <c:pt idx="3">
                    <c:v>6.134726067100052E-2</c:v>
                  </c:pt>
                  <c:pt idx="6">
                    <c:v>0.16455383050897107</c:v>
                  </c:pt>
                  <c:pt idx="9">
                    <c:v>9.8998192652590564E-2</c:v>
                  </c:pt>
                  <c:pt idx="12">
                    <c:v>0.17219013577101416</c:v>
                  </c:pt>
                  <c:pt idx="15">
                    <c:v>9.6533944399137747E-2</c:v>
                  </c:pt>
                  <c:pt idx="18">
                    <c:v>1.5083537553660868</c:v>
                  </c:pt>
                  <c:pt idx="21">
                    <c:v>3.333770902216147</c:v>
                  </c:pt>
                  <c:pt idx="24">
                    <c:v>47.60014386069119</c:v>
                  </c:pt>
                  <c:pt idx="27">
                    <c:v>1.4012633881351211</c:v>
                  </c:pt>
                  <c:pt idx="30">
                    <c:v>15.630632976762115</c:v>
                  </c:pt>
                </c:numCache>
              </c:numRef>
            </c:plus>
            <c:minus>
              <c:numRef>
                <c:f>'KB290'!$J$46:$J$78</c:f>
                <c:numCache>
                  <c:formatCode>General</c:formatCode>
                  <c:ptCount val="33"/>
                  <c:pt idx="0">
                    <c:v>0.25846385859953336</c:v>
                  </c:pt>
                  <c:pt idx="3">
                    <c:v>6.134726067100052E-2</c:v>
                  </c:pt>
                  <c:pt idx="6">
                    <c:v>0.16455383050897107</c:v>
                  </c:pt>
                  <c:pt idx="9">
                    <c:v>9.8998192652590564E-2</c:v>
                  </c:pt>
                  <c:pt idx="12">
                    <c:v>0.17219013577101416</c:v>
                  </c:pt>
                  <c:pt idx="15">
                    <c:v>9.6533944399137747E-2</c:v>
                  </c:pt>
                  <c:pt idx="18">
                    <c:v>1.5083537553660868</c:v>
                  </c:pt>
                  <c:pt idx="21">
                    <c:v>3.333770902216147</c:v>
                  </c:pt>
                  <c:pt idx="24">
                    <c:v>47.60014386069119</c:v>
                  </c:pt>
                  <c:pt idx="27">
                    <c:v>1.4012633881351211</c:v>
                  </c:pt>
                  <c:pt idx="30">
                    <c:v>15.630632976762115</c:v>
                  </c:pt>
                </c:numCache>
              </c:numRef>
            </c:minus>
          </c:errBars>
          <c:xVal>
            <c:numRef>
              <c:f>'KB290'!$F$46:$F$78</c:f>
              <c:numCache>
                <c:formatCode>General</c:formatCode>
                <c:ptCount val="33"/>
                <c:pt idx="0" formatCode="0.0000">
                  <c:v>5.6914539971670036E-2</c:v>
                </c:pt>
                <c:pt idx="3" formatCode="0.0000">
                  <c:v>0.15468756165672812</c:v>
                </c:pt>
                <c:pt idx="6" formatCode="0.0000">
                  <c:v>0.2876455532765651</c:v>
                </c:pt>
                <c:pt idx="9" formatCode="0.0000">
                  <c:v>0.46349156945268249</c:v>
                </c:pt>
                <c:pt idx="12" formatCode="0.0000">
                  <c:v>1.2628040903940569</c:v>
                </c:pt>
                <c:pt idx="15" formatCode="0.0000">
                  <c:v>2.1793410066343468</c:v>
                </c:pt>
                <c:pt idx="18" formatCode="0.0000">
                  <c:v>6.0504008765453401</c:v>
                </c:pt>
                <c:pt idx="21" formatCode="0.0000">
                  <c:v>10.173778197587472</c:v>
                </c:pt>
                <c:pt idx="24" formatCode="0.0000">
                  <c:v>13.140753984077781</c:v>
                </c:pt>
                <c:pt idx="27" formatCode="0.0000">
                  <c:v>23.111330341604262</c:v>
                </c:pt>
                <c:pt idx="30" formatCode="0.0000">
                  <c:v>41.554026989677418</c:v>
                </c:pt>
              </c:numCache>
            </c:numRef>
          </c:xVal>
          <c:yVal>
            <c:numRef>
              <c:f>'KB290'!$I$46:$I$78</c:f>
              <c:numCache>
                <c:formatCode>General</c:formatCode>
                <c:ptCount val="33"/>
                <c:pt idx="0" formatCode="0.00">
                  <c:v>11.077136500708249</c:v>
                </c:pt>
                <c:pt idx="3" formatCode="0.00">
                  <c:v>21.1328109585818</c:v>
                </c:pt>
                <c:pt idx="6" formatCode="0.00">
                  <c:v>30.308861168085873</c:v>
                </c:pt>
                <c:pt idx="9" formatCode="0.00">
                  <c:v>38.412710763682931</c:v>
                </c:pt>
                <c:pt idx="12" formatCode="0.00">
                  <c:v>55.92989774014859</c:v>
                </c:pt>
                <c:pt idx="15" formatCode="0.00">
                  <c:v>70.516474834141334</c:v>
                </c:pt>
                <c:pt idx="18" formatCode="0.00">
                  <c:v>98.73997808636652</c:v>
                </c:pt>
                <c:pt idx="21" formatCode="0.00">
                  <c:v>120.65554506031317</c:v>
                </c:pt>
                <c:pt idx="24" formatCode="0.00">
                  <c:v>171.48115039805552</c:v>
                </c:pt>
                <c:pt idx="27" formatCode="0.00">
                  <c:v>172.21674145989346</c:v>
                </c:pt>
                <c:pt idx="30" formatCode="0.00">
                  <c:v>211.149325258064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C2F-464D-B6B2-1AB6CE5203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13536"/>
        <c:axId val="287714112"/>
      </c:scatterChart>
      <c:valAx>
        <c:axId val="2877135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quilibrium P concentration [mg </a:t>
                </a:r>
                <a:r>
                  <a:rPr lang="en-US" sz="1000" b="1" i="0" u="none" strike="noStrike" baseline="0" dirty="0">
                    <a:effectLst/>
                  </a:rPr>
                  <a:t>L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4112"/>
        <c:crosses val="autoZero"/>
        <c:crossBetween val="midCat"/>
      </c:valAx>
      <c:valAx>
        <c:axId val="287714112"/>
        <c:scaling>
          <c:orientation val="minMax"/>
          <c:max val="3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 adsorbed [mg </a:t>
                </a:r>
                <a:r>
                  <a:rPr lang="en-US" sz="1000" b="1" i="0" u="none" strike="noStrike" baseline="0" dirty="0">
                    <a:effectLst/>
                  </a:rPr>
                  <a:t>kg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3536"/>
        <c:crosses val="autoZero"/>
        <c:crossBetween val="midCat"/>
        <c:majorUnit val="5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sz="1600" dirty="0" err="1"/>
              <a:t>mid</a:t>
            </a:r>
            <a:r>
              <a:rPr lang="de-DE" sz="1600" baseline="0" dirty="0"/>
              <a:t> slope-</a:t>
            </a:r>
            <a:r>
              <a:rPr lang="de-DE" sz="1600" dirty="0"/>
              <a:t>3</a:t>
            </a:r>
          </a:p>
        </c:rich>
      </c:tx>
      <c:layout>
        <c:manualLayout>
          <c:xMode val="edge"/>
          <c:yMode val="edge"/>
          <c:x val="0.19507797085169823"/>
          <c:y val="5.793874768412613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KB291'!$G$46:$G$78</c:f>
                <c:numCache>
                  <c:formatCode>General</c:formatCode>
                  <c:ptCount val="33"/>
                  <c:pt idx="0">
                    <c:v>8.1566411165309056E-3</c:v>
                  </c:pt>
                  <c:pt idx="3">
                    <c:v>1.6024107400760563E-2</c:v>
                  </c:pt>
                  <c:pt idx="6">
                    <c:v>6.5437627423652204E-3</c:v>
                  </c:pt>
                  <c:pt idx="9">
                    <c:v>4.3055705281156379E-3</c:v>
                  </c:pt>
                  <c:pt idx="12">
                    <c:v>1.9160785010196611E-2</c:v>
                  </c:pt>
                  <c:pt idx="15">
                    <c:v>3.7129953352304942E-2</c:v>
                  </c:pt>
                  <c:pt idx="18">
                    <c:v>3.1170542152143654E-2</c:v>
                  </c:pt>
                  <c:pt idx="21">
                    <c:v>0.15898168780827124</c:v>
                  </c:pt>
                  <c:pt idx="24">
                    <c:v>0.29085042233491293</c:v>
                  </c:pt>
                  <c:pt idx="27">
                    <c:v>0.39931092413314256</c:v>
                  </c:pt>
                  <c:pt idx="30">
                    <c:v>0.19924389461882747</c:v>
                  </c:pt>
                </c:numCache>
              </c:numRef>
            </c:plus>
            <c:minus>
              <c:numRef>
                <c:f>'KB291'!$G$46:$G$78</c:f>
                <c:numCache>
                  <c:formatCode>General</c:formatCode>
                  <c:ptCount val="33"/>
                  <c:pt idx="0">
                    <c:v>8.1566411165309056E-3</c:v>
                  </c:pt>
                  <c:pt idx="3">
                    <c:v>1.6024107400760563E-2</c:v>
                  </c:pt>
                  <c:pt idx="6">
                    <c:v>6.5437627423652204E-3</c:v>
                  </c:pt>
                  <c:pt idx="9">
                    <c:v>4.3055705281156379E-3</c:v>
                  </c:pt>
                  <c:pt idx="12">
                    <c:v>1.9160785010196611E-2</c:v>
                  </c:pt>
                  <c:pt idx="15">
                    <c:v>3.7129953352304942E-2</c:v>
                  </c:pt>
                  <c:pt idx="18">
                    <c:v>3.1170542152143654E-2</c:v>
                  </c:pt>
                  <c:pt idx="21">
                    <c:v>0.15898168780827124</c:v>
                  </c:pt>
                  <c:pt idx="24">
                    <c:v>0.29085042233491293</c:v>
                  </c:pt>
                  <c:pt idx="27">
                    <c:v>0.39931092413314256</c:v>
                  </c:pt>
                  <c:pt idx="30">
                    <c:v>0.19924389461882747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0"/>
            <c:plus>
              <c:numRef>
                <c:f>'KB291'!$J$46:$J$78</c:f>
                <c:numCache>
                  <c:formatCode>General</c:formatCode>
                  <c:ptCount val="33"/>
                  <c:pt idx="0">
                    <c:v>0.20391602791327326</c:v>
                  </c:pt>
                  <c:pt idx="3">
                    <c:v>0.40060268501901275</c:v>
                  </c:pt>
                  <c:pt idx="6">
                    <c:v>0.16359406855912703</c:v>
                  </c:pt>
                  <c:pt idx="9">
                    <c:v>0.10763926320289455</c:v>
                  </c:pt>
                  <c:pt idx="12">
                    <c:v>0.47901962525491421</c:v>
                  </c:pt>
                  <c:pt idx="15">
                    <c:v>0.92824883380762435</c:v>
                  </c:pt>
                  <c:pt idx="18">
                    <c:v>0.77926355380358736</c:v>
                  </c:pt>
                  <c:pt idx="21">
                    <c:v>3.9745421952067823</c:v>
                  </c:pt>
                  <c:pt idx="24">
                    <c:v>7.2712605583728243</c:v>
                  </c:pt>
                  <c:pt idx="27">
                    <c:v>9.9827731033285705</c:v>
                  </c:pt>
                  <c:pt idx="30">
                    <c:v>4.9810973654706823</c:v>
                  </c:pt>
                </c:numCache>
              </c:numRef>
            </c:plus>
            <c:minus>
              <c:numRef>
                <c:f>'KB291'!$J$46:$J$78</c:f>
                <c:numCache>
                  <c:formatCode>General</c:formatCode>
                  <c:ptCount val="33"/>
                  <c:pt idx="0">
                    <c:v>0.20391602791327326</c:v>
                  </c:pt>
                  <c:pt idx="3">
                    <c:v>0.40060268501901275</c:v>
                  </c:pt>
                  <c:pt idx="6">
                    <c:v>0.16359406855912703</c:v>
                  </c:pt>
                  <c:pt idx="9">
                    <c:v>0.10763926320289455</c:v>
                  </c:pt>
                  <c:pt idx="12">
                    <c:v>0.47901962525491421</c:v>
                  </c:pt>
                  <c:pt idx="15">
                    <c:v>0.92824883380762435</c:v>
                  </c:pt>
                  <c:pt idx="18">
                    <c:v>0.77926355380358736</c:v>
                  </c:pt>
                  <c:pt idx="21">
                    <c:v>3.9745421952067823</c:v>
                  </c:pt>
                  <c:pt idx="24">
                    <c:v>7.2712605583728243</c:v>
                  </c:pt>
                  <c:pt idx="27">
                    <c:v>9.9827731033285705</c:v>
                  </c:pt>
                  <c:pt idx="30">
                    <c:v>4.9810973654706823</c:v>
                  </c:pt>
                </c:numCache>
              </c:numRef>
            </c:minus>
          </c:errBars>
          <c:xVal>
            <c:numRef>
              <c:f>'KB291'!$F$46:$F$78</c:f>
              <c:numCache>
                <c:formatCode>General</c:formatCode>
                <c:ptCount val="33"/>
                <c:pt idx="0" formatCode="0.0000">
                  <c:v>3.1827867165004846E-2</c:v>
                </c:pt>
                <c:pt idx="3" formatCode="0.0000">
                  <c:v>7.6742192729232037E-2</c:v>
                </c:pt>
                <c:pt idx="6" formatCode="0.0000">
                  <c:v>0.15261124488470112</c:v>
                </c:pt>
                <c:pt idx="9" formatCode="0.0000">
                  <c:v>0.274190361867723</c:v>
                </c:pt>
                <c:pt idx="12" formatCode="0.0000">
                  <c:v>0.88105451104092236</c:v>
                </c:pt>
                <c:pt idx="15" formatCode="0.0000">
                  <c:v>1.774989930884334</c:v>
                </c:pt>
                <c:pt idx="18" formatCode="0.0000">
                  <c:v>5.919049975832718</c:v>
                </c:pt>
                <c:pt idx="21" formatCode="0.0000">
                  <c:v>10.312300628912709</c:v>
                </c:pt>
                <c:pt idx="24" formatCode="0.0000">
                  <c:v>14.667829182468038</c:v>
                </c:pt>
                <c:pt idx="27" formatCode="0.0000">
                  <c:v>23.260070864350894</c:v>
                </c:pt>
                <c:pt idx="30" formatCode="0.0000">
                  <c:v>41.659398369301847</c:v>
                </c:pt>
              </c:numCache>
            </c:numRef>
          </c:xVal>
          <c:yVal>
            <c:numRef>
              <c:f>'KB291'!$I$46:$I$78</c:f>
              <c:numCache>
                <c:formatCode>General</c:formatCode>
                <c:ptCount val="33"/>
                <c:pt idx="0" formatCode="0.00">
                  <c:v>11.70430332087488</c:v>
                </c:pt>
                <c:pt idx="3" formatCode="0.00">
                  <c:v>23.081445181769201</c:v>
                </c:pt>
                <c:pt idx="6" formatCode="0.00">
                  <c:v>33.684718877882482</c:v>
                </c:pt>
                <c:pt idx="9" formatCode="0.00">
                  <c:v>43.145240953306931</c:v>
                </c:pt>
                <c:pt idx="12" formatCode="0.00">
                  <c:v>65.473637223976951</c:v>
                </c:pt>
                <c:pt idx="15" formatCode="0.00">
                  <c:v>80.625251727891637</c:v>
                </c:pt>
                <c:pt idx="18" formatCode="0.00">
                  <c:v>102.02375060418206</c:v>
                </c:pt>
                <c:pt idx="21" formatCode="0.00">
                  <c:v>117.19248427718225</c:v>
                </c:pt>
                <c:pt idx="24" formatCode="0.00">
                  <c:v>133.30427043829906</c:v>
                </c:pt>
                <c:pt idx="27" formatCode="0.00">
                  <c:v>168.49822839122766</c:v>
                </c:pt>
                <c:pt idx="30" formatCode="0.00">
                  <c:v>208.515040767453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F25-45C7-8575-7E44669EFB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13536"/>
        <c:axId val="287714112"/>
      </c:scatterChart>
      <c:valAx>
        <c:axId val="2877135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quilibrium P concentration [mg </a:t>
                </a:r>
                <a:r>
                  <a:rPr lang="en-US" sz="1000" b="1" i="0" u="none" strike="noStrike" baseline="0" dirty="0">
                    <a:effectLst/>
                  </a:rPr>
                  <a:t>L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4112"/>
        <c:crosses val="autoZero"/>
        <c:crossBetween val="midCat"/>
      </c:valAx>
      <c:valAx>
        <c:axId val="287714112"/>
        <c:scaling>
          <c:orientation val="minMax"/>
          <c:max val="3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 adsorbed [mg </a:t>
                </a:r>
                <a:r>
                  <a:rPr lang="en-US" sz="1000" b="1" i="0" u="none" strike="noStrike" baseline="0" dirty="0">
                    <a:effectLst/>
                  </a:rPr>
                  <a:t>kg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3536"/>
        <c:crosses val="autoZero"/>
        <c:crossBetween val="midCat"/>
        <c:majorUnit val="5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sz="1600" dirty="0" err="1"/>
              <a:t>upper</a:t>
            </a:r>
            <a:r>
              <a:rPr lang="de-DE" sz="1600" dirty="0"/>
              <a:t> slope-1</a:t>
            </a:r>
          </a:p>
        </c:rich>
      </c:tx>
      <c:layout>
        <c:manualLayout>
          <c:xMode val="edge"/>
          <c:yMode val="edge"/>
          <c:x val="0.21348074606903067"/>
          <c:y val="3.847130722648774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038005890874371"/>
          <c:y val="3.2766477107028277E-2"/>
          <c:w val="0.79023759246986269"/>
          <c:h val="0.75308216681248175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KB292'!$G$46:$G$78</c:f>
                <c:numCache>
                  <c:formatCode>General</c:formatCode>
                  <c:ptCount val="33"/>
                  <c:pt idx="0">
                    <c:v>3.2851887663682612E-2</c:v>
                  </c:pt>
                  <c:pt idx="3">
                    <c:v>2.2547995194679735E-2</c:v>
                  </c:pt>
                  <c:pt idx="6">
                    <c:v>1.3748731168735444E-2</c:v>
                  </c:pt>
                  <c:pt idx="9">
                    <c:v>2.3431753810009615E-2</c:v>
                  </c:pt>
                  <c:pt idx="12">
                    <c:v>2.5491236340614855E-3</c:v>
                  </c:pt>
                  <c:pt idx="15">
                    <c:v>5.2671656439818387E-2</c:v>
                  </c:pt>
                  <c:pt idx="18">
                    <c:v>6.573277443233895E-2</c:v>
                  </c:pt>
                  <c:pt idx="21">
                    <c:v>5.8552021681470522E-2</c:v>
                  </c:pt>
                  <c:pt idx="24">
                    <c:v>9.624723560720623E-2</c:v>
                  </c:pt>
                  <c:pt idx="27">
                    <c:v>0.3454575955238724</c:v>
                  </c:pt>
                  <c:pt idx="30">
                    <c:v>0.66452864792173549</c:v>
                  </c:pt>
                </c:numCache>
              </c:numRef>
            </c:plus>
            <c:minus>
              <c:numRef>
                <c:f>'KB292'!$G$46:$G$78</c:f>
                <c:numCache>
                  <c:formatCode>General</c:formatCode>
                  <c:ptCount val="33"/>
                  <c:pt idx="0">
                    <c:v>3.2851887663682612E-2</c:v>
                  </c:pt>
                  <c:pt idx="3">
                    <c:v>2.2547995194679735E-2</c:v>
                  </c:pt>
                  <c:pt idx="6">
                    <c:v>1.3748731168735444E-2</c:v>
                  </c:pt>
                  <c:pt idx="9">
                    <c:v>2.3431753810009615E-2</c:v>
                  </c:pt>
                  <c:pt idx="12">
                    <c:v>2.5491236340614855E-3</c:v>
                  </c:pt>
                  <c:pt idx="15">
                    <c:v>5.2671656439818387E-2</c:v>
                  </c:pt>
                  <c:pt idx="18">
                    <c:v>6.573277443233895E-2</c:v>
                  </c:pt>
                  <c:pt idx="21">
                    <c:v>5.8552021681470522E-2</c:v>
                  </c:pt>
                  <c:pt idx="24">
                    <c:v>9.624723560720623E-2</c:v>
                  </c:pt>
                  <c:pt idx="27">
                    <c:v>0.3454575955238724</c:v>
                  </c:pt>
                  <c:pt idx="30">
                    <c:v>0.66452864792173549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0"/>
            <c:plus>
              <c:numRef>
                <c:f>'KB292'!$J$46:$J$78</c:f>
                <c:numCache>
                  <c:formatCode>General</c:formatCode>
                  <c:ptCount val="33"/>
                  <c:pt idx="0">
                    <c:v>0.82129719159206671</c:v>
                  </c:pt>
                  <c:pt idx="3">
                    <c:v>0.56369987986699377</c:v>
                  </c:pt>
                  <c:pt idx="6">
                    <c:v>0.34371827921838599</c:v>
                  </c:pt>
                  <c:pt idx="9">
                    <c:v>0.58579384525024114</c:v>
                  </c:pt>
                  <c:pt idx="12">
                    <c:v>6.3728090851535676E-2</c:v>
                  </c:pt>
                  <c:pt idx="15">
                    <c:v>1.3167914109954608</c:v>
                  </c:pt>
                  <c:pt idx="18">
                    <c:v>1.6433193608084731</c:v>
                  </c:pt>
                  <c:pt idx="21">
                    <c:v>1.463800542036763</c:v>
                  </c:pt>
                  <c:pt idx="24">
                    <c:v>2.4061808901801576</c:v>
                  </c:pt>
                  <c:pt idx="27">
                    <c:v>8.6364398880968114</c:v>
                  </c:pt>
                  <c:pt idx="30">
                    <c:v>16.613216198043379</c:v>
                  </c:pt>
                </c:numCache>
              </c:numRef>
            </c:plus>
            <c:minus>
              <c:numRef>
                <c:f>'KB292'!$J$46:$J$78</c:f>
                <c:numCache>
                  <c:formatCode>General</c:formatCode>
                  <c:ptCount val="33"/>
                  <c:pt idx="0">
                    <c:v>0.82129719159206671</c:v>
                  </c:pt>
                  <c:pt idx="3">
                    <c:v>0.56369987986699377</c:v>
                  </c:pt>
                  <c:pt idx="6">
                    <c:v>0.34371827921838599</c:v>
                  </c:pt>
                  <c:pt idx="9">
                    <c:v>0.58579384525024114</c:v>
                  </c:pt>
                  <c:pt idx="12">
                    <c:v>6.3728090851535676E-2</c:v>
                  </c:pt>
                  <c:pt idx="15">
                    <c:v>1.3167914109954608</c:v>
                  </c:pt>
                  <c:pt idx="18">
                    <c:v>1.6433193608084731</c:v>
                  </c:pt>
                  <c:pt idx="21">
                    <c:v>1.463800542036763</c:v>
                  </c:pt>
                  <c:pt idx="24">
                    <c:v>2.4061808901801576</c:v>
                  </c:pt>
                  <c:pt idx="27">
                    <c:v>8.6364398880968114</c:v>
                  </c:pt>
                  <c:pt idx="30">
                    <c:v>16.613216198043379</c:v>
                  </c:pt>
                </c:numCache>
              </c:numRef>
            </c:minus>
          </c:errBars>
          <c:xVal>
            <c:numRef>
              <c:f>'KB292'!$F$46:$F$78</c:f>
              <c:numCache>
                <c:formatCode>General</c:formatCode>
                <c:ptCount val="33"/>
                <c:pt idx="0" formatCode="0.0000">
                  <c:v>0.2110157495276499</c:v>
                </c:pt>
                <c:pt idx="3" formatCode="0.0000">
                  <c:v>0.3334011764554648</c:v>
                </c:pt>
                <c:pt idx="6" formatCode="0.0000">
                  <c:v>0.52608427229667853</c:v>
                </c:pt>
                <c:pt idx="9" formatCode="0.0000">
                  <c:v>0.71792430429994225</c:v>
                </c:pt>
                <c:pt idx="12" formatCode="0.0000">
                  <c:v>1.5897121656185609</c:v>
                </c:pt>
                <c:pt idx="15" formatCode="0.0000">
                  <c:v>2.543871779440193</c:v>
                </c:pt>
                <c:pt idx="18" formatCode="0.0000">
                  <c:v>6.2800269952366188</c:v>
                </c:pt>
                <c:pt idx="21" formatCode="0.0000">
                  <c:v>10.807243330665694</c:v>
                </c:pt>
                <c:pt idx="24" formatCode="0.0000">
                  <c:v>15.045725246785549</c:v>
                </c:pt>
                <c:pt idx="27" formatCode="0.0000">
                  <c:v>24.064324829151332</c:v>
                </c:pt>
                <c:pt idx="30" formatCode="0.0000">
                  <c:v>42.291059161725535</c:v>
                </c:pt>
              </c:numCache>
            </c:numRef>
          </c:xVal>
          <c:yVal>
            <c:numRef>
              <c:f>'KB286'!$I$46:$I$78</c:f>
              <c:numCache>
                <c:formatCode>General</c:formatCode>
                <c:ptCount val="33"/>
                <c:pt idx="0" formatCode="0.00">
                  <c:v>5.1165027539658006</c:v>
                </c:pt>
                <c:pt idx="3" formatCode="0.00">
                  <c:v>12.99190904010892</c:v>
                </c:pt>
                <c:pt idx="6" formatCode="0.00">
                  <c:v>19.92188001853734</c:v>
                </c:pt>
                <c:pt idx="9" formatCode="0.00">
                  <c:v>24.831824103060072</c:v>
                </c:pt>
                <c:pt idx="12" formatCode="0.00">
                  <c:v>39.747104074977663</c:v>
                </c:pt>
                <c:pt idx="15" formatCode="0.00">
                  <c:v>49.31214843811324</c:v>
                </c:pt>
                <c:pt idx="18" formatCode="0.00">
                  <c:v>78.45766772486715</c:v>
                </c:pt>
                <c:pt idx="21" formatCode="0.00">
                  <c:v>89.7014077067534</c:v>
                </c:pt>
                <c:pt idx="24" formatCode="0.00">
                  <c:v>105.97070384642872</c:v>
                </c:pt>
                <c:pt idx="27" formatCode="0.00">
                  <c:v>144.96461420170829</c:v>
                </c:pt>
                <c:pt idx="30" formatCode="0.00">
                  <c:v>226.244333008088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30B-4927-A6F4-D0B4CEA6E0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13536"/>
        <c:axId val="287714112"/>
      </c:scatterChart>
      <c:valAx>
        <c:axId val="287713536"/>
        <c:scaling>
          <c:orientation val="minMax"/>
          <c:max val="5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quilibrium P concentration [mg L</a:t>
                </a:r>
                <a:r>
                  <a:rPr lang="en-US" baseline="30000" dirty="0"/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4112"/>
        <c:crosses val="autoZero"/>
        <c:crossBetween val="midCat"/>
      </c:valAx>
      <c:valAx>
        <c:axId val="287714112"/>
        <c:scaling>
          <c:orientation val="minMax"/>
          <c:max val="3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 adsorbed [mg kg</a:t>
                </a:r>
                <a:r>
                  <a:rPr lang="en-US" baseline="30000" dirty="0"/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3536"/>
        <c:crosses val="autoZero"/>
        <c:crossBetween val="midCat"/>
        <c:majorUnit val="5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sz="1600" dirty="0" err="1"/>
              <a:t>upper</a:t>
            </a:r>
            <a:r>
              <a:rPr lang="de-DE" sz="1600" dirty="0"/>
              <a:t> slope-2</a:t>
            </a:r>
          </a:p>
        </c:rich>
      </c:tx>
      <c:layout>
        <c:manualLayout>
          <c:xMode val="edge"/>
          <c:yMode val="edge"/>
          <c:x val="0.20942123320614359"/>
          <c:y val="6.4672762661414071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KB293'!$G$46:$G$78</c:f>
                <c:numCache>
                  <c:formatCode>General</c:formatCode>
                  <c:ptCount val="33"/>
                  <c:pt idx="0">
                    <c:v>2.5495923494178734E-3</c:v>
                  </c:pt>
                  <c:pt idx="3">
                    <c:v>1.3500899843249502E-2</c:v>
                  </c:pt>
                  <c:pt idx="6">
                    <c:v>1.0566323896008426E-2</c:v>
                  </c:pt>
                  <c:pt idx="9">
                    <c:v>1.4508202028530953E-2</c:v>
                  </c:pt>
                  <c:pt idx="12">
                    <c:v>3.7581151687701826E-2</c:v>
                  </c:pt>
                  <c:pt idx="15">
                    <c:v>7.7821356584727441E-3</c:v>
                  </c:pt>
                  <c:pt idx="18">
                    <c:v>0.15394326411536308</c:v>
                  </c:pt>
                  <c:pt idx="21">
                    <c:v>0.1967682662684313</c:v>
                  </c:pt>
                  <c:pt idx="24">
                    <c:v>0.26765987280323483</c:v>
                  </c:pt>
                  <c:pt idx="27">
                    <c:v>0.37796790197897062</c:v>
                  </c:pt>
                  <c:pt idx="30">
                    <c:v>0.37658400500643724</c:v>
                  </c:pt>
                </c:numCache>
              </c:numRef>
            </c:plus>
            <c:minus>
              <c:numRef>
                <c:f>'KB293'!$G$46:$G$78</c:f>
                <c:numCache>
                  <c:formatCode>General</c:formatCode>
                  <c:ptCount val="33"/>
                  <c:pt idx="0">
                    <c:v>2.5495923494178734E-3</c:v>
                  </c:pt>
                  <c:pt idx="3">
                    <c:v>1.3500899843249502E-2</c:v>
                  </c:pt>
                  <c:pt idx="6">
                    <c:v>1.0566323896008426E-2</c:v>
                  </c:pt>
                  <c:pt idx="9">
                    <c:v>1.4508202028530953E-2</c:v>
                  </c:pt>
                  <c:pt idx="12">
                    <c:v>3.7581151687701826E-2</c:v>
                  </c:pt>
                  <c:pt idx="15">
                    <c:v>7.7821356584727441E-3</c:v>
                  </c:pt>
                  <c:pt idx="18">
                    <c:v>0.15394326411536308</c:v>
                  </c:pt>
                  <c:pt idx="21">
                    <c:v>0.1967682662684313</c:v>
                  </c:pt>
                  <c:pt idx="24">
                    <c:v>0.26765987280323483</c:v>
                  </c:pt>
                  <c:pt idx="27">
                    <c:v>0.37796790197897062</c:v>
                  </c:pt>
                  <c:pt idx="30">
                    <c:v>0.37658400500643724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0"/>
            <c:plus>
              <c:numRef>
                <c:f>'KB293'!$J$46:$J$78</c:f>
                <c:numCache>
                  <c:formatCode>General</c:formatCode>
                  <c:ptCount val="33"/>
                  <c:pt idx="0">
                    <c:v>6.373980873544656E-2</c:v>
                  </c:pt>
                  <c:pt idx="3">
                    <c:v>0.33752249608123769</c:v>
                  </c:pt>
                  <c:pt idx="6">
                    <c:v>0.26415809740021051</c:v>
                  </c:pt>
                  <c:pt idx="9">
                    <c:v>0.36270505071327364</c:v>
                  </c:pt>
                  <c:pt idx="12">
                    <c:v>0.93952879219254648</c:v>
                  </c:pt>
                  <c:pt idx="15">
                    <c:v>0.19455339146182199</c:v>
                  </c:pt>
                  <c:pt idx="18">
                    <c:v>3.848581602884082</c:v>
                  </c:pt>
                  <c:pt idx="21">
                    <c:v>4.9192066567107791</c:v>
                  </c:pt>
                  <c:pt idx="24">
                    <c:v>6.6914968200808636</c:v>
                  </c:pt>
                  <c:pt idx="27">
                    <c:v>9.4491975494742686</c:v>
                  </c:pt>
                  <c:pt idx="30">
                    <c:v>9.4146001251609306</c:v>
                  </c:pt>
                </c:numCache>
              </c:numRef>
            </c:plus>
            <c:minus>
              <c:numRef>
                <c:f>'KB293'!$J$46:$J$78</c:f>
                <c:numCache>
                  <c:formatCode>General</c:formatCode>
                  <c:ptCount val="33"/>
                  <c:pt idx="0">
                    <c:v>6.373980873544656E-2</c:v>
                  </c:pt>
                  <c:pt idx="3">
                    <c:v>0.33752249608123769</c:v>
                  </c:pt>
                  <c:pt idx="6">
                    <c:v>0.26415809740021051</c:v>
                  </c:pt>
                  <c:pt idx="9">
                    <c:v>0.36270505071327364</c:v>
                  </c:pt>
                  <c:pt idx="12">
                    <c:v>0.93952879219254648</c:v>
                  </c:pt>
                  <c:pt idx="15">
                    <c:v>0.19455339146182199</c:v>
                  </c:pt>
                  <c:pt idx="18">
                    <c:v>3.848581602884082</c:v>
                  </c:pt>
                  <c:pt idx="21">
                    <c:v>4.9192066567107791</c:v>
                  </c:pt>
                  <c:pt idx="24">
                    <c:v>6.6914968200808636</c:v>
                  </c:pt>
                  <c:pt idx="27">
                    <c:v>9.4491975494742686</c:v>
                  </c:pt>
                  <c:pt idx="30">
                    <c:v>9.4146001251609306</c:v>
                  </c:pt>
                </c:numCache>
              </c:numRef>
            </c:minus>
          </c:errBars>
          <c:xVal>
            <c:numRef>
              <c:f>'KB293'!$F$46:$F$78</c:f>
              <c:numCache>
                <c:formatCode>General</c:formatCode>
                <c:ptCount val="33"/>
                <c:pt idx="0" formatCode="0.0000">
                  <c:v>0.10512424679936634</c:v>
                </c:pt>
                <c:pt idx="3" formatCode="0.0000">
                  <c:v>0.19944061847801517</c:v>
                </c:pt>
                <c:pt idx="6" formatCode="0.0000">
                  <c:v>0.32765856216349803</c:v>
                </c:pt>
                <c:pt idx="9" formatCode="0.0000">
                  <c:v>0.50060961543518623</c:v>
                </c:pt>
                <c:pt idx="12" formatCode="0.0000">
                  <c:v>1.2440177813235265</c:v>
                </c:pt>
                <c:pt idx="15" formatCode="0.0000">
                  <c:v>2.2436784101539913</c:v>
                </c:pt>
                <c:pt idx="18" formatCode="0.0000">
                  <c:v>5.8058660258823878</c:v>
                </c:pt>
                <c:pt idx="21" formatCode="0.0000">
                  <c:v>9.9622178127530798</c:v>
                </c:pt>
                <c:pt idx="24" formatCode="0.0000">
                  <c:v>14.319559164338061</c:v>
                </c:pt>
                <c:pt idx="27" formatCode="0.0000">
                  <c:v>23.285941708827806</c:v>
                </c:pt>
                <c:pt idx="30" formatCode="0.0000">
                  <c:v>41.387704018205731</c:v>
                </c:pt>
              </c:numCache>
            </c:numRef>
          </c:xVal>
          <c:yVal>
            <c:numRef>
              <c:f>'KB293'!$I$46:$I$78</c:f>
              <c:numCache>
                <c:formatCode>General</c:formatCode>
                <c:ptCount val="33"/>
                <c:pt idx="0" formatCode="0.00">
                  <c:v>9.871893830015841</c:v>
                </c:pt>
                <c:pt idx="3" formatCode="0.00">
                  <c:v>20.013984538049623</c:v>
                </c:pt>
                <c:pt idx="6" formatCode="0.00">
                  <c:v>29.308535945912553</c:v>
                </c:pt>
                <c:pt idx="9" formatCode="0.00">
                  <c:v>37.48475961412035</c:v>
                </c:pt>
                <c:pt idx="12" formatCode="0.00">
                  <c:v>56.399555466911842</c:v>
                </c:pt>
                <c:pt idx="15" formatCode="0.00">
                  <c:v>68.908039746150223</c:v>
                </c:pt>
                <c:pt idx="18" formatCode="0.00">
                  <c:v>104.85334935294031</c:v>
                </c:pt>
                <c:pt idx="21" formatCode="0.00">
                  <c:v>125.94455468117299</c:v>
                </c:pt>
                <c:pt idx="24" formatCode="0.00">
                  <c:v>142.01102089154847</c:v>
                </c:pt>
                <c:pt idx="27" formatCode="0.00">
                  <c:v>167.85145727930487</c:v>
                </c:pt>
                <c:pt idx="30" formatCode="0.00">
                  <c:v>215.307399544856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F33-4AF9-8E66-04994AB2D8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13536"/>
        <c:axId val="287714112"/>
      </c:scatterChart>
      <c:valAx>
        <c:axId val="287713536"/>
        <c:scaling>
          <c:orientation val="minMax"/>
          <c:max val="5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quilibrium P concentration [mg </a:t>
                </a:r>
                <a:r>
                  <a:rPr lang="en-US" sz="1000" b="1" i="0" u="none" strike="noStrike" baseline="0" dirty="0">
                    <a:effectLst/>
                  </a:rPr>
                  <a:t>L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4112"/>
        <c:crosses val="autoZero"/>
        <c:crossBetween val="midCat"/>
      </c:valAx>
      <c:valAx>
        <c:axId val="287714112"/>
        <c:scaling>
          <c:orientation val="minMax"/>
          <c:max val="3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 adsorbed [mg </a:t>
                </a:r>
                <a:r>
                  <a:rPr lang="en-US" sz="1000" b="1" i="0" u="none" strike="noStrike" baseline="0" dirty="0">
                    <a:effectLst/>
                  </a:rPr>
                  <a:t>kg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layout>
            <c:manualLayout>
              <c:xMode val="edge"/>
              <c:yMode val="edge"/>
              <c:x val="4.9372815596242021E-2"/>
              <c:y val="0.1508449642110988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3536"/>
        <c:crosses val="autoZero"/>
        <c:crossBetween val="midCat"/>
        <c:majorUnit val="5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de-DE" sz="1600" dirty="0" err="1"/>
              <a:t>upper</a:t>
            </a:r>
            <a:r>
              <a:rPr lang="de-DE" sz="1600" baseline="0" dirty="0"/>
              <a:t> slope-</a:t>
            </a:r>
            <a:r>
              <a:rPr lang="de-DE" sz="1600" dirty="0"/>
              <a:t>3</a:t>
            </a:r>
          </a:p>
        </c:rich>
      </c:tx>
      <c:layout>
        <c:manualLayout>
          <c:xMode val="edge"/>
          <c:yMode val="edge"/>
          <c:x val="0.21349344278064578"/>
          <c:y val="3.4554958959404448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KB294'!$G$46:$G$78</c:f>
                <c:numCache>
                  <c:formatCode>General</c:formatCode>
                  <c:ptCount val="33"/>
                  <c:pt idx="0">
                    <c:v>3.7006473306084469E-3</c:v>
                  </c:pt>
                  <c:pt idx="3">
                    <c:v>5.1270265718817119E-3</c:v>
                  </c:pt>
                  <c:pt idx="6">
                    <c:v>1.6434572479130945E-2</c:v>
                  </c:pt>
                  <c:pt idx="9">
                    <c:v>1.0983557039784056E-2</c:v>
                  </c:pt>
                  <c:pt idx="12">
                    <c:v>2.4444637038574104E-2</c:v>
                  </c:pt>
                  <c:pt idx="15">
                    <c:v>0.11526167237341632</c:v>
                  </c:pt>
                  <c:pt idx="18">
                    <c:v>0.20576032050966339</c:v>
                  </c:pt>
                  <c:pt idx="21">
                    <c:v>0.33008043641726903</c:v>
                  </c:pt>
                  <c:pt idx="24">
                    <c:v>0.15189023597106793</c:v>
                  </c:pt>
                  <c:pt idx="27">
                    <c:v>0.29864947367143996</c:v>
                  </c:pt>
                  <c:pt idx="30">
                    <c:v>0.69483437030630391</c:v>
                  </c:pt>
                </c:numCache>
              </c:numRef>
            </c:plus>
            <c:minus>
              <c:numRef>
                <c:f>'KB294'!$G$46:$G$78</c:f>
                <c:numCache>
                  <c:formatCode>General</c:formatCode>
                  <c:ptCount val="33"/>
                  <c:pt idx="0">
                    <c:v>3.7006473306084469E-3</c:v>
                  </c:pt>
                  <c:pt idx="3">
                    <c:v>5.1270265718817119E-3</c:v>
                  </c:pt>
                  <c:pt idx="6">
                    <c:v>1.6434572479130945E-2</c:v>
                  </c:pt>
                  <c:pt idx="9">
                    <c:v>1.0983557039784056E-2</c:v>
                  </c:pt>
                  <c:pt idx="12">
                    <c:v>2.4444637038574104E-2</c:v>
                  </c:pt>
                  <c:pt idx="15">
                    <c:v>0.11526167237341632</c:v>
                  </c:pt>
                  <c:pt idx="18">
                    <c:v>0.20576032050966339</c:v>
                  </c:pt>
                  <c:pt idx="21">
                    <c:v>0.33008043641726903</c:v>
                  </c:pt>
                  <c:pt idx="24">
                    <c:v>0.15189023597106793</c:v>
                  </c:pt>
                  <c:pt idx="27">
                    <c:v>0.29864947367143996</c:v>
                  </c:pt>
                  <c:pt idx="30">
                    <c:v>0.69483437030630391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0"/>
            <c:plus>
              <c:numRef>
                <c:f>'KB294'!$J$46:$J$78</c:f>
                <c:numCache>
                  <c:formatCode>General</c:formatCode>
                  <c:ptCount val="33"/>
                  <c:pt idx="0">
                    <c:v>9.2516183265210897E-2</c:v>
                  </c:pt>
                  <c:pt idx="3">
                    <c:v>0.12817566429704211</c:v>
                  </c:pt>
                  <c:pt idx="6">
                    <c:v>0.41086431197827528</c:v>
                  </c:pt>
                  <c:pt idx="9">
                    <c:v>0.27458892599460222</c:v>
                  </c:pt>
                  <c:pt idx="12">
                    <c:v>0.61111592596436148</c:v>
                  </c:pt>
                  <c:pt idx="15">
                    <c:v>2.8815418093354026</c:v>
                  </c:pt>
                  <c:pt idx="18">
                    <c:v>5.1440080127415921</c:v>
                  </c:pt>
                  <c:pt idx="21">
                    <c:v>8.2520109104317445</c:v>
                  </c:pt>
                  <c:pt idx="24">
                    <c:v>3.7972558992766996</c:v>
                  </c:pt>
                  <c:pt idx="27">
                    <c:v>7.4662368417859728</c:v>
                  </c:pt>
                  <c:pt idx="30">
                    <c:v>17.37085925765761</c:v>
                  </c:pt>
                </c:numCache>
              </c:numRef>
            </c:plus>
            <c:minus>
              <c:numRef>
                <c:f>'KB294'!$J$46:$J$78</c:f>
                <c:numCache>
                  <c:formatCode>General</c:formatCode>
                  <c:ptCount val="33"/>
                  <c:pt idx="0">
                    <c:v>9.2516183265210897E-2</c:v>
                  </c:pt>
                  <c:pt idx="3">
                    <c:v>0.12817566429704211</c:v>
                  </c:pt>
                  <c:pt idx="6">
                    <c:v>0.41086431197827528</c:v>
                  </c:pt>
                  <c:pt idx="9">
                    <c:v>0.27458892599460222</c:v>
                  </c:pt>
                  <c:pt idx="12">
                    <c:v>0.61111592596436148</c:v>
                  </c:pt>
                  <c:pt idx="15">
                    <c:v>2.8815418093354026</c:v>
                  </c:pt>
                  <c:pt idx="18">
                    <c:v>5.1440080127415921</c:v>
                  </c:pt>
                  <c:pt idx="21">
                    <c:v>8.2520109104317445</c:v>
                  </c:pt>
                  <c:pt idx="24">
                    <c:v>3.7972558992766996</c:v>
                  </c:pt>
                  <c:pt idx="27">
                    <c:v>7.4662368417859728</c:v>
                  </c:pt>
                  <c:pt idx="30">
                    <c:v>17.37085925765761</c:v>
                  </c:pt>
                </c:numCache>
              </c:numRef>
            </c:minus>
          </c:errBars>
          <c:xVal>
            <c:numRef>
              <c:f>'KB294'!$F$46:$F$78</c:f>
              <c:numCache>
                <c:formatCode>General</c:formatCode>
                <c:ptCount val="33"/>
                <c:pt idx="0" formatCode="0.0000">
                  <c:v>2.5798929711249672E-2</c:v>
                </c:pt>
                <c:pt idx="3" formatCode="0.0000">
                  <c:v>4.3664979558417936E-2</c:v>
                </c:pt>
                <c:pt idx="6" formatCode="0.0000">
                  <c:v>9.2833093451362814E-2</c:v>
                </c:pt>
                <c:pt idx="9" formatCode="0.0000">
                  <c:v>0.1861103604205776</c:v>
                </c:pt>
                <c:pt idx="12" formatCode="0.0000">
                  <c:v>0.6457520893917067</c:v>
                </c:pt>
                <c:pt idx="15" formatCode="0.0000">
                  <c:v>1.2956840816345661</c:v>
                </c:pt>
                <c:pt idx="18" formatCode="0.0000">
                  <c:v>4.8004992319271773</c:v>
                </c:pt>
                <c:pt idx="21" formatCode="0.0000">
                  <c:v>9.0094938278483561</c:v>
                </c:pt>
                <c:pt idx="24" formatCode="0.0000">
                  <c:v>13.848805568315925</c:v>
                </c:pt>
                <c:pt idx="27" formatCode="0.0000">
                  <c:v>18.207647434794278</c:v>
                </c:pt>
                <c:pt idx="30" formatCode="0.0000">
                  <c:v>40.44767101798093</c:v>
                </c:pt>
              </c:numCache>
            </c:numRef>
          </c:xVal>
          <c:yVal>
            <c:numRef>
              <c:f>'KB294'!$I$46:$I$78</c:f>
              <c:numCache>
                <c:formatCode>General</c:formatCode>
                <c:ptCount val="33"/>
                <c:pt idx="0" formatCode="0.00">
                  <c:v>11.855026757218759</c:v>
                </c:pt>
                <c:pt idx="3" formatCode="0.00">
                  <c:v>23.908375511039551</c:v>
                </c:pt>
                <c:pt idx="6" formatCode="0.00">
                  <c:v>35.179172663715931</c:v>
                </c:pt>
                <c:pt idx="9" formatCode="0.00">
                  <c:v>45.347240989485563</c:v>
                </c:pt>
                <c:pt idx="12" formatCode="0.00">
                  <c:v>71.356197765207341</c:v>
                </c:pt>
                <c:pt idx="15" formatCode="0.00">
                  <c:v>92.607897959135855</c:v>
                </c:pt>
                <c:pt idx="18" formatCode="0.00">
                  <c:v>129.98751920182056</c:v>
                </c:pt>
                <c:pt idx="21" formatCode="0.00">
                  <c:v>149.76265430379109</c:v>
                </c:pt>
                <c:pt idx="24" formatCode="0.00">
                  <c:v>153.77986079210191</c:v>
                </c:pt>
                <c:pt idx="27" formatCode="0.00">
                  <c:v>294.80881413014305</c:v>
                </c:pt>
                <c:pt idx="30" formatCode="0.00">
                  <c:v>238.808224550476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C3C-4253-90E8-441557B09B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13536"/>
        <c:axId val="287714112"/>
      </c:scatterChart>
      <c:valAx>
        <c:axId val="2877135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quilibrium P concentration [mg </a:t>
                </a:r>
                <a:r>
                  <a:rPr lang="en-US" sz="1000" b="1" i="0" u="none" strike="noStrike" baseline="0" dirty="0">
                    <a:effectLst/>
                  </a:rPr>
                  <a:t>L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4112"/>
        <c:crosses val="autoZero"/>
        <c:crossBetween val="midCat"/>
      </c:valAx>
      <c:valAx>
        <c:axId val="287714112"/>
        <c:scaling>
          <c:orientation val="minMax"/>
          <c:max val="3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 adsorbed [mg </a:t>
                </a:r>
                <a:r>
                  <a:rPr lang="en-US" sz="1000" b="1" i="0" u="none" strike="noStrike" baseline="0" dirty="0">
                    <a:effectLst/>
                  </a:rPr>
                  <a:t>kg</a:t>
                </a:r>
                <a:r>
                  <a:rPr lang="en-US" sz="1000" b="1" i="0" u="none" strike="noStrike" baseline="30000" dirty="0">
                    <a:effectLst/>
                  </a:rPr>
                  <a:t>-1</a:t>
                </a:r>
                <a:r>
                  <a:rPr lang="en-US" dirty="0"/>
                  <a:t>]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87713536"/>
        <c:crosses val="autoZero"/>
        <c:crossBetween val="midCat"/>
        <c:majorUnit val="5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5427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06778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3347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1009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3614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3153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8880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9972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3195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7663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8691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C168F6-E1C3-4BE9-97FB-57AD7CCC46F5}" type="datetimeFigureOut">
              <a:rPr lang="de-DE" smtClean="0"/>
              <a:t>19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34F92-BD56-48D3-B2ED-443BF7A0BF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9145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>
            <a:extLst>
              <a:ext uri="{FF2B5EF4-FFF2-40B4-BE49-F238E27FC236}">
                <a16:creationId xmlns:a16="http://schemas.microsoft.com/office/drawing/2014/main" id="{5E409A17-280D-4416-B5AD-B681763BEF97}"/>
              </a:ext>
            </a:extLst>
          </p:cNvPr>
          <p:cNvSpPr/>
          <p:nvPr/>
        </p:nvSpPr>
        <p:spPr>
          <a:xfrm>
            <a:off x="772048" y="512544"/>
            <a:ext cx="7528573" cy="19363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9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tle: 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peciation and sorption of phosphorus in agricultural soil profiles of redoximorphic character</a:t>
            </a:r>
          </a:p>
          <a:p>
            <a:pPr algn="just">
              <a:lnSpc>
                <a:spcPct val="150000"/>
              </a:lnSpc>
            </a:pPr>
            <a:endParaRPr lang="en-GB" sz="900" b="1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de-DE" sz="9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ournal: </a:t>
            </a:r>
            <a:r>
              <a:rPr lang="de-DE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vironmental </a:t>
            </a:r>
            <a:r>
              <a:rPr lang="de-DE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ochemistry</a:t>
            </a:r>
            <a:r>
              <a:rPr lang="de-DE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Health</a:t>
            </a:r>
          </a:p>
          <a:p>
            <a:pPr algn="just">
              <a:lnSpc>
                <a:spcPct val="150000"/>
              </a:lnSpc>
            </a:pPr>
            <a:endParaRPr lang="de-DE" sz="9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GB" sz="9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uthors: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Karen Baumann</a:t>
            </a:r>
            <a:r>
              <a:rPr lang="en-GB" sz="9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Sabry M. </a:t>
            </a:r>
            <a:r>
              <a:rPr lang="en-GB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haheen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GB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Yongfeng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u, Peter Gros, Elena </a:t>
            </a:r>
            <a:r>
              <a:rPr lang="en-GB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ilmann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ohsen </a:t>
            </a:r>
            <a:r>
              <a:rPr lang="en-GB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orshedizad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GB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ianxu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ang, Shan-Li Wang, </a:t>
            </a:r>
            <a:r>
              <a:rPr lang="en-GB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örg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nklebe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Peter Leinweber</a:t>
            </a:r>
          </a:p>
          <a:p>
            <a:pPr algn="just">
              <a:lnSpc>
                <a:spcPct val="150000"/>
              </a:lnSpc>
            </a:pPr>
            <a:endParaRPr lang="en-GB" sz="9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*Corresponding author: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niversity of Rostock, Faculty of Agricultural and Environmental Science, Soil Science, Justus-von-Liebig-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Weg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6, 18051 Rostock, Germany; e-mail: karen.baumann@web.de</a:t>
            </a:r>
            <a:endParaRPr lang="de-DE" sz="9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01085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>
            <a:extLst>
              <a:ext uri="{FF2B5EF4-FFF2-40B4-BE49-F238E27FC236}">
                <a16:creationId xmlns:a16="http://schemas.microsoft.com/office/drawing/2014/main" id="{2557D017-A698-4B2B-A3DD-A991D96FA0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0284193"/>
              </p:ext>
            </p:extLst>
          </p:nvPr>
        </p:nvGraphicFramePr>
        <p:xfrm>
          <a:off x="6026638" y="639738"/>
          <a:ext cx="3087300" cy="19366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Diagramm 2">
            <a:extLst>
              <a:ext uri="{FF2B5EF4-FFF2-40B4-BE49-F238E27FC236}">
                <a16:creationId xmlns:a16="http://schemas.microsoft.com/office/drawing/2014/main" id="{E6A05729-9F44-4C8B-BBDF-4E2DE7EE65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343894"/>
              </p:ext>
            </p:extLst>
          </p:nvPr>
        </p:nvGraphicFramePr>
        <p:xfrm>
          <a:off x="5878858" y="2609981"/>
          <a:ext cx="3273012" cy="21408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458086C3-01F5-4D9F-9198-307D30F630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4446604"/>
              </p:ext>
            </p:extLst>
          </p:nvPr>
        </p:nvGraphicFramePr>
        <p:xfrm>
          <a:off x="5878858" y="4668236"/>
          <a:ext cx="3273012" cy="2207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Diagramm 4">
            <a:extLst>
              <a:ext uri="{FF2B5EF4-FFF2-40B4-BE49-F238E27FC236}">
                <a16:creationId xmlns:a16="http://schemas.microsoft.com/office/drawing/2014/main" id="{8349D115-AACF-469F-BE01-61E2828CAF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1622922"/>
              </p:ext>
            </p:extLst>
          </p:nvPr>
        </p:nvGraphicFramePr>
        <p:xfrm>
          <a:off x="2934924" y="596527"/>
          <a:ext cx="3087300" cy="1936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Diagramm 5">
            <a:extLst>
              <a:ext uri="{FF2B5EF4-FFF2-40B4-BE49-F238E27FC236}">
                <a16:creationId xmlns:a16="http://schemas.microsoft.com/office/drawing/2014/main" id="{34C01EFF-FCEF-4C9B-A50B-5F45E94341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2940406"/>
              </p:ext>
            </p:extLst>
          </p:nvPr>
        </p:nvGraphicFramePr>
        <p:xfrm>
          <a:off x="2814320" y="2611953"/>
          <a:ext cx="3293441" cy="21408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Diagramm 6">
            <a:extLst>
              <a:ext uri="{FF2B5EF4-FFF2-40B4-BE49-F238E27FC236}">
                <a16:creationId xmlns:a16="http://schemas.microsoft.com/office/drawing/2014/main" id="{D0C59EAC-9BCB-4DCF-B439-532E7ADC359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5137345"/>
              </p:ext>
            </p:extLst>
          </p:nvPr>
        </p:nvGraphicFramePr>
        <p:xfrm>
          <a:off x="2814321" y="4685922"/>
          <a:ext cx="3282688" cy="2207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Diagramm 7">
            <a:extLst>
              <a:ext uri="{FF2B5EF4-FFF2-40B4-BE49-F238E27FC236}">
                <a16:creationId xmlns:a16="http://schemas.microsoft.com/office/drawing/2014/main" id="{95506C0C-BD1A-4647-B6A5-1C206898F86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161646"/>
              </p:ext>
            </p:extLst>
          </p:nvPr>
        </p:nvGraphicFramePr>
        <p:xfrm>
          <a:off x="-55127" y="560667"/>
          <a:ext cx="3030523" cy="1972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Diagramm 8">
            <a:extLst>
              <a:ext uri="{FF2B5EF4-FFF2-40B4-BE49-F238E27FC236}">
                <a16:creationId xmlns:a16="http://schemas.microsoft.com/office/drawing/2014/main" id="{DF227A19-0CB5-4010-A703-7CC9310A7E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6681739"/>
              </p:ext>
            </p:extLst>
          </p:nvPr>
        </p:nvGraphicFramePr>
        <p:xfrm>
          <a:off x="-100012" y="2568743"/>
          <a:ext cx="3118700" cy="21840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Diagramm 9">
            <a:extLst>
              <a:ext uri="{FF2B5EF4-FFF2-40B4-BE49-F238E27FC236}">
                <a16:creationId xmlns:a16="http://schemas.microsoft.com/office/drawing/2014/main" id="{5D10A3AE-1ABE-4C7F-A686-86F98C80CA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181267"/>
              </p:ext>
            </p:extLst>
          </p:nvPr>
        </p:nvGraphicFramePr>
        <p:xfrm>
          <a:off x="-100012" y="4709455"/>
          <a:ext cx="3118700" cy="21840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1" name="Textfeld 10">
            <a:extLst>
              <a:ext uri="{FF2B5EF4-FFF2-40B4-BE49-F238E27FC236}">
                <a16:creationId xmlns:a16="http://schemas.microsoft.com/office/drawing/2014/main" id="{8B7D3DAE-9260-4950-8646-4861C9163A1A}"/>
              </a:ext>
            </a:extLst>
          </p:cNvPr>
          <p:cNvSpPr txBox="1"/>
          <p:nvPr/>
        </p:nvSpPr>
        <p:spPr>
          <a:xfrm>
            <a:off x="8136618" y="1803617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y= 20.21 x</a:t>
            </a:r>
            <a:r>
              <a:rPr lang="de-DE" sz="1000" baseline="30000" dirty="0"/>
              <a:t>0.65</a:t>
            </a:r>
          </a:p>
          <a:p>
            <a:r>
              <a:rPr lang="de-DE" sz="1000" dirty="0"/>
              <a:t>r</a:t>
            </a:r>
            <a:r>
              <a:rPr lang="de-DE" sz="1000" baseline="30000" dirty="0"/>
              <a:t>2</a:t>
            </a:r>
            <a:r>
              <a:rPr lang="de-DE" sz="1000" dirty="0"/>
              <a:t> =  0.9528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07DD7690-E112-494E-90A1-9792C7670BFA}"/>
              </a:ext>
            </a:extLst>
          </p:cNvPr>
          <p:cNvSpPr txBox="1"/>
          <p:nvPr/>
        </p:nvSpPr>
        <p:spPr>
          <a:xfrm>
            <a:off x="5012915" y="1758037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y= 33.11 x</a:t>
            </a:r>
            <a:r>
              <a:rPr lang="de-DE" sz="1000" baseline="30000" dirty="0"/>
              <a:t>0.62</a:t>
            </a:r>
          </a:p>
          <a:p>
            <a:r>
              <a:rPr lang="de-DE" sz="1000" dirty="0"/>
              <a:t>r</a:t>
            </a:r>
            <a:r>
              <a:rPr lang="de-DE" sz="1000" baseline="30000" dirty="0"/>
              <a:t>2</a:t>
            </a:r>
            <a:r>
              <a:rPr lang="de-DE" sz="1000" dirty="0"/>
              <a:t> =  0.9678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6BDB68B-8318-4800-AF1C-6DA4503FB6FA}"/>
              </a:ext>
            </a:extLst>
          </p:cNvPr>
          <p:cNvSpPr txBox="1"/>
          <p:nvPr/>
        </p:nvSpPr>
        <p:spPr>
          <a:xfrm>
            <a:off x="1948377" y="1751131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y= 29.98 x</a:t>
            </a:r>
            <a:r>
              <a:rPr lang="de-DE" sz="1000" baseline="30000" dirty="0"/>
              <a:t>0.54</a:t>
            </a:r>
          </a:p>
          <a:p>
            <a:r>
              <a:rPr lang="de-DE" sz="1000" dirty="0"/>
              <a:t>r</a:t>
            </a:r>
            <a:r>
              <a:rPr lang="de-DE" sz="1000" baseline="30000" dirty="0"/>
              <a:t>2</a:t>
            </a:r>
            <a:r>
              <a:rPr lang="de-DE" sz="1000" dirty="0"/>
              <a:t> =  0.9390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78B4650C-4DBE-4E29-899B-0D5F692BF8A3}"/>
              </a:ext>
            </a:extLst>
          </p:cNvPr>
          <p:cNvSpPr txBox="1"/>
          <p:nvPr/>
        </p:nvSpPr>
        <p:spPr>
          <a:xfrm>
            <a:off x="8159391" y="3751822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y= 45.03 x</a:t>
            </a:r>
            <a:r>
              <a:rPr lang="de-DE" sz="1000" baseline="30000" dirty="0"/>
              <a:t>0.37</a:t>
            </a:r>
          </a:p>
          <a:p>
            <a:r>
              <a:rPr lang="de-DE" sz="1000" dirty="0"/>
              <a:t>r</a:t>
            </a:r>
            <a:r>
              <a:rPr lang="de-DE" sz="1000" baseline="30000" dirty="0"/>
              <a:t>2</a:t>
            </a:r>
            <a:r>
              <a:rPr lang="de-DE" sz="1000" dirty="0"/>
              <a:t> =  0.9736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563498C9-9526-4384-94FB-D41CB0F1B301}"/>
              </a:ext>
            </a:extLst>
          </p:cNvPr>
          <p:cNvSpPr txBox="1"/>
          <p:nvPr/>
        </p:nvSpPr>
        <p:spPr>
          <a:xfrm>
            <a:off x="5070318" y="3739683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y= 47.37 x</a:t>
            </a:r>
            <a:r>
              <a:rPr lang="de-DE" sz="1000" baseline="30000" dirty="0"/>
              <a:t>0.35</a:t>
            </a:r>
          </a:p>
          <a:p>
            <a:r>
              <a:rPr lang="de-DE" sz="1000" dirty="0"/>
              <a:t>r</a:t>
            </a:r>
            <a:r>
              <a:rPr lang="de-DE" sz="1000" baseline="30000" dirty="0"/>
              <a:t>2</a:t>
            </a:r>
            <a:r>
              <a:rPr lang="de-DE" sz="1000" dirty="0"/>
              <a:t> =  0.9731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6A2E817D-857E-4D4C-9DDE-018655C450E3}"/>
              </a:ext>
            </a:extLst>
          </p:cNvPr>
          <p:cNvSpPr txBox="1"/>
          <p:nvPr/>
        </p:nvSpPr>
        <p:spPr>
          <a:xfrm>
            <a:off x="1950855" y="3719496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y= 42.76 x</a:t>
            </a:r>
            <a:r>
              <a:rPr lang="de-DE" sz="1000" baseline="30000" dirty="0"/>
              <a:t>0.47</a:t>
            </a:r>
          </a:p>
          <a:p>
            <a:r>
              <a:rPr lang="de-DE" sz="1000" dirty="0"/>
              <a:t>r</a:t>
            </a:r>
            <a:r>
              <a:rPr lang="de-DE" sz="1000" baseline="30000" dirty="0"/>
              <a:t>2</a:t>
            </a:r>
            <a:r>
              <a:rPr lang="de-DE" sz="1000" dirty="0"/>
              <a:t> =  0.9661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E8608BA0-C5D7-4474-8EE5-80046D26C29C}"/>
              </a:ext>
            </a:extLst>
          </p:cNvPr>
          <p:cNvSpPr txBox="1"/>
          <p:nvPr/>
        </p:nvSpPr>
        <p:spPr>
          <a:xfrm>
            <a:off x="8136618" y="5916543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y= 40.78 x</a:t>
            </a:r>
            <a:r>
              <a:rPr lang="de-DE" sz="1000" baseline="30000" dirty="0"/>
              <a:t>0.48</a:t>
            </a:r>
          </a:p>
          <a:p>
            <a:r>
              <a:rPr lang="de-DE" sz="1000" dirty="0"/>
              <a:t>r</a:t>
            </a:r>
            <a:r>
              <a:rPr lang="de-DE" sz="1000" baseline="30000" dirty="0"/>
              <a:t>2</a:t>
            </a:r>
            <a:r>
              <a:rPr lang="de-DE" sz="1000" dirty="0"/>
              <a:t> =  0.9743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33FB9C65-6841-4820-8851-63A8C312B3C8}"/>
              </a:ext>
            </a:extLst>
          </p:cNvPr>
          <p:cNvSpPr txBox="1"/>
          <p:nvPr/>
        </p:nvSpPr>
        <p:spPr>
          <a:xfrm>
            <a:off x="5058297" y="5918018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y= 57.03 x</a:t>
            </a:r>
            <a:r>
              <a:rPr lang="de-DE" sz="1000" baseline="30000" dirty="0"/>
              <a:t>0.35</a:t>
            </a:r>
          </a:p>
          <a:p>
            <a:r>
              <a:rPr lang="de-DE" sz="1000" dirty="0"/>
              <a:t>r</a:t>
            </a:r>
            <a:r>
              <a:rPr lang="de-DE" sz="1000" baseline="30000" dirty="0"/>
              <a:t>2</a:t>
            </a:r>
            <a:r>
              <a:rPr lang="de-DE" sz="1000" dirty="0"/>
              <a:t> =  0.9640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C1055D36-5DA5-41B3-8127-AA28077935A7}"/>
              </a:ext>
            </a:extLst>
          </p:cNvPr>
          <p:cNvSpPr txBox="1"/>
          <p:nvPr/>
        </p:nvSpPr>
        <p:spPr>
          <a:xfrm>
            <a:off x="2003436" y="5916543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y= 72.79 x</a:t>
            </a:r>
            <a:r>
              <a:rPr lang="de-DE" sz="1000" baseline="30000" dirty="0"/>
              <a:t>0.37</a:t>
            </a:r>
          </a:p>
          <a:p>
            <a:r>
              <a:rPr lang="de-DE" sz="1000" dirty="0"/>
              <a:t>r</a:t>
            </a:r>
            <a:r>
              <a:rPr lang="de-DE" sz="1000" baseline="30000" dirty="0"/>
              <a:t>2</a:t>
            </a:r>
            <a:r>
              <a:rPr lang="de-DE" sz="1000" dirty="0"/>
              <a:t> =  0.9473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853C0398-F138-4473-A82F-70DF0637234E}"/>
              </a:ext>
            </a:extLst>
          </p:cNvPr>
          <p:cNvSpPr txBox="1"/>
          <p:nvPr/>
        </p:nvSpPr>
        <p:spPr>
          <a:xfrm>
            <a:off x="0" y="0"/>
            <a:ext cx="908387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3: 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 adsorption isotherms for soils from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ree depths (1-3) of the upper, mid and toe slope soil profile. </a:t>
            </a:r>
            <a:r>
              <a:rPr lang="en-GB" sz="1400" i="1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</a:t>
            </a:r>
            <a:r>
              <a:rPr lang="en-GB" sz="14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GB" sz="1400" i="1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</a:t>
            </a:r>
            <a:r>
              <a:rPr lang="en-GB" sz="14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efficients can be derived from the equation (y= </a:t>
            </a:r>
            <a:r>
              <a:rPr lang="en-GB" sz="1400" i="1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</a:t>
            </a:r>
            <a:r>
              <a:rPr lang="en-GB" sz="14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GB" sz="1400" i="1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</a:t>
            </a:r>
            <a:r>
              <a:rPr lang="en-GB" sz="14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∙ </a:t>
            </a:r>
            <a:r>
              <a:rPr lang="en-GB" sz="14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x</a:t>
            </a:r>
            <a:r>
              <a:rPr lang="en-GB" sz="1400" i="1" baseline="30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f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; bars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dicate standard deviation, n = 3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640220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37</Words>
  <Application>Microsoft Office PowerPoint</Application>
  <PresentationFormat>Bildschirmpräsentation (4:3)</PresentationFormat>
  <Paragraphs>53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ren Baumann</dc:creator>
  <cp:lastModifiedBy>Karen Baumann</cp:lastModifiedBy>
  <cp:revision>20</cp:revision>
  <dcterms:created xsi:type="dcterms:W3CDTF">2019-07-25T10:57:55Z</dcterms:created>
  <dcterms:modified xsi:type="dcterms:W3CDTF">2019-12-19T10:55:37Z</dcterms:modified>
</cp:coreProperties>
</file>